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8" r:id="rId1"/>
  </p:sldMasterIdLst>
  <p:notesMasterIdLst>
    <p:notesMasterId r:id="rId8"/>
  </p:notesMasterIdLst>
  <p:sldIdLst>
    <p:sldId id="888" r:id="rId2"/>
    <p:sldId id="267" r:id="rId3"/>
    <p:sldId id="889" r:id="rId4"/>
    <p:sldId id="268" r:id="rId5"/>
    <p:sldId id="880" r:id="rId6"/>
    <p:sldId id="886" r:id="rId7"/>
  </p:sldIdLst>
  <p:sldSz cx="6858000" cy="9144000" type="screen4x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69" autoAdjust="0"/>
    <p:restoredTop sz="96340" autoAdjust="0"/>
  </p:normalViewPr>
  <p:slideViewPr>
    <p:cSldViewPr snapToGrid="0" showGuides="1">
      <p:cViewPr varScale="1">
        <p:scale>
          <a:sx n="83" d="100"/>
          <a:sy n="83" d="100"/>
        </p:scale>
        <p:origin x="2940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247" cy="498328"/>
          </a:xfrm>
          <a:prstGeom prst="rect">
            <a:avLst/>
          </a:prstGeom>
        </p:spPr>
        <p:txBody>
          <a:bodyPr vert="horz" lIns="92108" tIns="46054" rIns="92108" bIns="46054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826" y="0"/>
            <a:ext cx="2946246" cy="498328"/>
          </a:xfrm>
          <a:prstGeom prst="rect">
            <a:avLst/>
          </a:prstGeom>
        </p:spPr>
        <p:txBody>
          <a:bodyPr vert="horz" lIns="92108" tIns="46054" rIns="92108" bIns="46054" rtlCol="0"/>
          <a:lstStyle>
            <a:lvl1pPr algn="r">
              <a:defRPr sz="1200"/>
            </a:lvl1pPr>
          </a:lstStyle>
          <a:p>
            <a:fld id="{10CAC413-9228-4C2B-AB57-8BEE5A712C65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108" tIns="46054" rIns="92108" bIns="46054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288" y="4777245"/>
            <a:ext cx="5439101" cy="3908363"/>
          </a:xfrm>
          <a:prstGeom prst="rect">
            <a:avLst/>
          </a:prstGeom>
        </p:spPr>
        <p:txBody>
          <a:bodyPr vert="horz" lIns="92108" tIns="46054" rIns="92108" bIns="46054" rtlCol="0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310"/>
            <a:ext cx="2946247" cy="498328"/>
          </a:xfrm>
          <a:prstGeom prst="rect">
            <a:avLst/>
          </a:prstGeom>
        </p:spPr>
        <p:txBody>
          <a:bodyPr vert="horz" lIns="92108" tIns="46054" rIns="92108" bIns="46054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826" y="9428310"/>
            <a:ext cx="2946246" cy="498328"/>
          </a:xfrm>
          <a:prstGeom prst="rect">
            <a:avLst/>
          </a:prstGeom>
        </p:spPr>
        <p:txBody>
          <a:bodyPr vert="horz" lIns="92108" tIns="46054" rIns="92108" bIns="46054" rtlCol="0" anchor="b"/>
          <a:lstStyle>
            <a:lvl1pPr algn="r">
              <a:defRPr sz="1200"/>
            </a:lvl1pPr>
          </a:lstStyle>
          <a:p>
            <a:fld id="{D444E2C6-A893-48D0-A620-0FE6D94D3E1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703012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1075">
              <a:defRPr/>
            </a:pPr>
            <a:r>
              <a:rPr lang="en-US" altLang="ko-KR" sz="18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4. Validation of </a:t>
            </a:r>
            <a:r>
              <a:rPr lang="en-US" altLang="ko-KR" sz="1800" b="1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18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data using ELISA assays. 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levels of adiponectin, TIMP4, and IGFBP2 exhibited significant increases in individuals with Alzheimer's disease when assessed using both </a:t>
            </a:r>
            <a:r>
              <a:rPr lang="en-US" altLang="ko-KR" sz="18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8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ELISA </a:t>
            </a:r>
            <a:r>
              <a:rPr lang="en-US" altLang="ko-KR" sz="18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')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Expression levels of FGA, ENO1, and IGFBP7 were significantly altered in subjects with high OA</a:t>
            </a:r>
            <a:r>
              <a:rPr lang="el-GR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 values as determined by the </a:t>
            </a:r>
            <a:r>
              <a:rPr lang="en-US" altLang="ko-KR" sz="18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ssay </a:t>
            </a:r>
            <a:r>
              <a:rPr lang="en-US" altLang="ko-KR" sz="18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)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ELISA measurements </a:t>
            </a:r>
            <a:r>
              <a:rPr lang="en-US" altLang="ko-KR" sz="1800" b="1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')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did not show statistically significant changes, though the direction of these changes closely mirrored the results obtained from the </a:t>
            </a:r>
            <a:r>
              <a:rPr lang="en-US" altLang="ko-KR" sz="1800" kern="100" dirty="0" err="1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1800" kern="100" dirty="0">
                <a:latin typeface="Arial" panose="020B0604020202020204" pitchFamily="34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ssay.</a:t>
            </a:r>
            <a:endParaRPr lang="ko-KR" altLang="ko-KR" sz="1800" kern="100" dirty="0"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444E2C6-A893-48D0-A620-0FE6D94D3E16}" type="slidenum">
              <a:rPr lang="ko-KR" altLang="en-US" smtClean="0"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19016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1890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815065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344699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32796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7677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76539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47274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351156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300834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127963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15166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211925-46BC-4897-9A83-C07CB6E98F83}" type="datetimeFigureOut">
              <a:rPr lang="ko-KR" altLang="en-US" smtClean="0"/>
              <a:t>2026-02-1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918252-D91F-46AC-8F5E-446FEA79333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003184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9" r:id="rId1"/>
    <p:sldLayoutId id="2147483700" r:id="rId2"/>
    <p:sldLayoutId id="2147483701" r:id="rId3"/>
    <p:sldLayoutId id="2147483702" r:id="rId4"/>
    <p:sldLayoutId id="2147483703" r:id="rId5"/>
    <p:sldLayoutId id="2147483704" r:id="rId6"/>
    <p:sldLayoutId id="2147483705" r:id="rId7"/>
    <p:sldLayoutId id="2147483706" r:id="rId8"/>
    <p:sldLayoutId id="2147483707" r:id="rId9"/>
    <p:sldLayoutId id="2147483708" r:id="rId10"/>
    <p:sldLayoutId id="2147483709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png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51FCA95-804C-D443-1F83-1AB7D161B49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F0F4D51F-DB10-78D7-F0DE-AFE24D383041}"/>
              </a:ext>
            </a:extLst>
          </p:cNvPr>
          <p:cNvSpPr txBox="1">
            <a:spLocks/>
          </p:cNvSpPr>
          <p:nvPr/>
        </p:nvSpPr>
        <p:spPr>
          <a:xfrm>
            <a:off x="471488" y="447648"/>
            <a:ext cx="5915025" cy="40408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s</a:t>
            </a:r>
            <a:endParaRPr lang="ko-KR" altLang="en-US" sz="1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743ED4-2A62-FA2B-80A9-4EEBC4CAF375}"/>
              </a:ext>
            </a:extLst>
          </p:cNvPr>
          <p:cNvSpPr txBox="1"/>
          <p:nvPr/>
        </p:nvSpPr>
        <p:spPr>
          <a:xfrm>
            <a:off x="309624" y="851734"/>
            <a:ext cx="6447097" cy="376987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latinLnBrk="0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1.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hanges of the plasma proteome in subjects with mismatched PET and OAβT results. </a:t>
            </a:r>
          </a:p>
          <a:p>
            <a:pPr algn="just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2.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ifferentially expressed proteins and associated GO terms across OA</a:t>
            </a:r>
            <a:r>
              <a:rPr lang="el-GR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 and OA</a:t>
            </a:r>
            <a:r>
              <a:rPr lang="el-GR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 Groups in AD and non-AD comparisons. </a:t>
            </a:r>
            <a:endParaRPr lang="ko-KR" altLang="ko-KR" sz="10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0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3. Upregulated proteins in AD or OA</a:t>
            </a:r>
            <a:r>
              <a:rPr lang="el-GR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/AD- groups compared to OA</a:t>
            </a:r>
            <a:r>
              <a:rPr lang="el-GR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/AD- groups.</a:t>
            </a:r>
            <a:endParaRPr lang="ko-KR" altLang="ko-KR" sz="10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0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4. Downregulated proteins in AD or OA</a:t>
            </a:r>
            <a:r>
              <a:rPr lang="el-GR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/AD- groups compared to OA</a:t>
            </a:r>
            <a:r>
              <a:rPr lang="el-GR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/AD- groups.</a:t>
            </a:r>
            <a:endParaRPr lang="ko-KR" altLang="ko-KR" sz="10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  <a:p>
            <a:pPr algn="just" latinLnBrk="0">
              <a:lnSpc>
                <a:spcPct val="200000"/>
              </a:lnSpc>
              <a:spcAft>
                <a:spcPts val="800"/>
              </a:spcAft>
            </a:pP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5. Validation of SOMAscan data using ELISA assays. </a:t>
            </a:r>
            <a:endParaRPr lang="ko-KR" altLang="ko-KR" sz="1000" kern="100" dirty="0">
              <a:effectLst/>
              <a:latin typeface="맑은 고딕" panose="020B0503020000020004" pitchFamily="50" charset="-127"/>
              <a:ea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43687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8" name="Picture 327">
            <a:extLst>
              <a:ext uri="{FF2B5EF4-FFF2-40B4-BE49-F238E27FC236}">
                <a16:creationId xmlns:a16="http://schemas.microsoft.com/office/drawing/2014/main" id="{66163D86-6A6E-F060-E10A-30DBED17E48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08456" y="6390608"/>
            <a:ext cx="809106" cy="986400"/>
          </a:xfrm>
          <a:prstGeom prst="rect">
            <a:avLst/>
          </a:prstGeom>
        </p:spPr>
      </p:pic>
      <p:sp>
        <p:nvSpPr>
          <p:cNvPr id="202" name="TextBox 201">
            <a:extLst>
              <a:ext uri="{FF2B5EF4-FFF2-40B4-BE49-F238E27FC236}">
                <a16:creationId xmlns:a16="http://schemas.microsoft.com/office/drawing/2014/main" id="{20F78B6F-8977-31B1-9687-DAAD26EA55A9}"/>
              </a:ext>
            </a:extLst>
          </p:cNvPr>
          <p:cNvSpPr txBox="1"/>
          <p:nvPr/>
        </p:nvSpPr>
        <p:spPr>
          <a:xfrm>
            <a:off x="3466828" y="379119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D9C04427-29F5-6E92-2D5B-4A33A88374E2}"/>
              </a:ext>
            </a:extLst>
          </p:cNvPr>
          <p:cNvSpPr txBox="1">
            <a:spLocks/>
          </p:cNvSpPr>
          <p:nvPr/>
        </p:nvSpPr>
        <p:spPr>
          <a:xfrm>
            <a:off x="66676" y="-3245"/>
            <a:ext cx="6772272" cy="9416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hanges of the plasma proteome in subjects with mismatched PET and OAβT results.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8D2236-9447-7EE1-7565-C71F5DE0798D}"/>
              </a:ext>
            </a:extLst>
          </p:cNvPr>
          <p:cNvSpPr txBox="1"/>
          <p:nvPr/>
        </p:nvSpPr>
        <p:spPr>
          <a:xfrm>
            <a:off x="25245" y="7647374"/>
            <a:ext cx="6813703" cy="15696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Volcano plots showing the differential protein expression of clinically non-AD patients with 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high OAβT  value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OAβT+/AD-)</a:t>
            </a:r>
            <a:r>
              <a:rPr lang="en-US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d 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linically AD patients with low OAβT value (OAβT-/AD+)</a:t>
            </a:r>
            <a:r>
              <a:rPr lang="en-US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) 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mpared to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clinically non-AD patients with low OAβT value (OAβT-/AD-).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C)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t plots of the 3 most upregulated (MIC-1, HSPB6, SLIT1) and downregulated proteins (Lamin-B1, FCSD1, MBD4) in OAβT+/AD- compared to OAβT-/AD- group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</a:t>
            </a:r>
            <a:r>
              <a:rPr lang="en-US" altLang="ko-KR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D) 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ot plots of the 3 most upregulated (MIC-1, THAP4, SARP-2) and down-regulated proteins (</a:t>
            </a:r>
            <a:r>
              <a:rPr lang="en-US" altLang="ko-KR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emokine</a:t>
            </a:r>
            <a:r>
              <a:rPr lang="en-US" altLang="ko-KR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, NHRF3, Selenium-binding protein 1) in OAβT-/AD+ compared to OAβT-/AD- group. Proteins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were measured in relative fluorescence units (RFUs). Red lines represent the mean and standard error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374AF79-AC0C-F2A1-B32E-DC25A671C661}"/>
              </a:ext>
            </a:extLst>
          </p:cNvPr>
          <p:cNvSpPr txBox="1"/>
          <p:nvPr/>
        </p:nvSpPr>
        <p:spPr>
          <a:xfrm>
            <a:off x="260195" y="932209"/>
            <a:ext cx="415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BA97E2CA-70E8-1FA4-44B7-B63599085A00}"/>
              </a:ext>
            </a:extLst>
          </p:cNvPr>
          <p:cNvGrpSpPr/>
          <p:nvPr/>
        </p:nvGrpSpPr>
        <p:grpSpPr>
          <a:xfrm>
            <a:off x="452777" y="1129683"/>
            <a:ext cx="2876122" cy="3088930"/>
            <a:chOff x="374585" y="4258644"/>
            <a:chExt cx="2876122" cy="3088930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C7A62134-12F9-F947-2BA1-78E79F351A8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0707" y="4484670"/>
              <a:ext cx="2700000" cy="2700000"/>
            </a:xfrm>
            <a:prstGeom prst="rect">
              <a:avLst/>
            </a:prstGeom>
          </p:spPr>
        </p:pic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075244C-0513-BC9F-8C58-FF2222F29397}"/>
                </a:ext>
              </a:extLst>
            </p:cNvPr>
            <p:cNvSpPr txBox="1"/>
            <p:nvPr/>
          </p:nvSpPr>
          <p:spPr>
            <a:xfrm>
              <a:off x="705868" y="4258644"/>
              <a:ext cx="197234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OA</a:t>
              </a:r>
              <a:r>
                <a:rPr lang="el-GR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+/AD- vs OAβT-/AD-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F5DDF41-0D9C-BD65-D5ED-3DE8B973ED60}"/>
                </a:ext>
              </a:extLst>
            </p:cNvPr>
            <p:cNvSpPr txBox="1"/>
            <p:nvPr/>
          </p:nvSpPr>
          <p:spPr>
            <a:xfrm rot="16200000">
              <a:off x="-658190" y="5771989"/>
              <a:ext cx="228099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-log10p-valu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640D727-D2B6-C53E-682A-E1519CCC4752}"/>
                </a:ext>
              </a:extLst>
            </p:cNvPr>
            <p:cNvSpPr txBox="1"/>
            <p:nvPr/>
          </p:nvSpPr>
          <p:spPr>
            <a:xfrm>
              <a:off x="626572" y="7132130"/>
              <a:ext cx="193168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log2FC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7" name="Group 36">
            <a:extLst>
              <a:ext uri="{FF2B5EF4-FFF2-40B4-BE49-F238E27FC236}">
                <a16:creationId xmlns:a16="http://schemas.microsoft.com/office/drawing/2014/main" id="{6AB5615C-1262-2CBD-D690-5E3F834C1304}"/>
              </a:ext>
            </a:extLst>
          </p:cNvPr>
          <p:cNvGrpSpPr/>
          <p:nvPr/>
        </p:nvGrpSpPr>
        <p:grpSpPr>
          <a:xfrm>
            <a:off x="462301" y="4526142"/>
            <a:ext cx="2882174" cy="3072520"/>
            <a:chOff x="7392745" y="1914242"/>
            <a:chExt cx="2882174" cy="3072520"/>
          </a:xfrm>
        </p:grpSpPr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6F5D0D33-131A-AA2D-2AF4-0F1046EF521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574919" y="2124467"/>
              <a:ext cx="2700000" cy="2700000"/>
            </a:xfrm>
            <a:prstGeom prst="rect">
              <a:avLst/>
            </a:prstGeom>
          </p:spPr>
        </p:pic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724DE1F-E299-B933-0D8B-48640AD4592F}"/>
                </a:ext>
              </a:extLst>
            </p:cNvPr>
            <p:cNvSpPr txBox="1"/>
            <p:nvPr/>
          </p:nvSpPr>
          <p:spPr>
            <a:xfrm>
              <a:off x="7697306" y="1914242"/>
              <a:ext cx="1972342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lIns="0" rIns="0" rtlCol="0">
              <a:spAutoFit/>
            </a:bodyPr>
            <a:lstStyle/>
            <a:p>
              <a:pPr algn="ctr"/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OA</a:t>
              </a:r>
              <a:r>
                <a:rPr lang="el-GR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-/AD+ vs OAβT-/AD-</a:t>
              </a:r>
              <a:endParaRPr lang="ko-KR" altLang="en-US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87DDDE0-161F-0872-BC53-B873F486ED43}"/>
                </a:ext>
              </a:extLst>
            </p:cNvPr>
            <p:cNvSpPr txBox="1"/>
            <p:nvPr/>
          </p:nvSpPr>
          <p:spPr>
            <a:xfrm rot="16200000">
              <a:off x="6359970" y="3392127"/>
              <a:ext cx="2280994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-log10p-value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8859BE3-4634-17B2-21E7-4612D5FB3EF9}"/>
                </a:ext>
              </a:extLst>
            </p:cNvPr>
            <p:cNvSpPr txBox="1"/>
            <p:nvPr/>
          </p:nvSpPr>
          <p:spPr>
            <a:xfrm>
              <a:off x="7645526" y="4771318"/>
              <a:ext cx="1931683" cy="215444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dirty="0">
                  <a:latin typeface="Arial" panose="020B0604020202020204" pitchFamily="34" charset="0"/>
                  <a:cs typeface="Arial" panose="020B0604020202020204" pitchFamily="34" charset="0"/>
                </a:rPr>
                <a:t>log2FC</a:t>
              </a:r>
              <a:endParaRPr lang="ko-KR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60D1B0D5-2016-3CA8-45F6-CC347725E50E}"/>
              </a:ext>
            </a:extLst>
          </p:cNvPr>
          <p:cNvSpPr txBox="1"/>
          <p:nvPr/>
        </p:nvSpPr>
        <p:spPr>
          <a:xfrm>
            <a:off x="261450" y="4355520"/>
            <a:ext cx="415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B3CB288-A50D-908C-5BFB-76AC738FD1B9}"/>
              </a:ext>
            </a:extLst>
          </p:cNvPr>
          <p:cNvSpPr txBox="1"/>
          <p:nvPr/>
        </p:nvSpPr>
        <p:spPr>
          <a:xfrm>
            <a:off x="1869214" y="1431453"/>
            <a:ext cx="381067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C-1</a:t>
            </a:r>
            <a:endParaRPr lang="ko-KR" altLang="en-US" sz="5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34D12D90-9BB2-00C6-98D1-D9229C6D3794}"/>
              </a:ext>
            </a:extLst>
          </p:cNvPr>
          <p:cNvSpPr txBox="1"/>
          <p:nvPr/>
        </p:nvSpPr>
        <p:spPr>
          <a:xfrm>
            <a:off x="1199620" y="2006334"/>
            <a:ext cx="5509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min-B1</a:t>
            </a:r>
            <a:endParaRPr lang="ko-KR" altLang="en-US" sz="5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DEDD94D-CC87-60EB-A84B-5052F98807D2}"/>
              </a:ext>
            </a:extLst>
          </p:cNvPr>
          <p:cNvSpPr txBox="1"/>
          <p:nvPr/>
        </p:nvSpPr>
        <p:spPr>
          <a:xfrm>
            <a:off x="1810795" y="2208945"/>
            <a:ext cx="92840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SPB6</a:t>
            </a:r>
            <a:endParaRPr lang="ko-KR" altLang="en-US" sz="5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768A2D3-1949-E135-7B94-6C679F61813B}"/>
              </a:ext>
            </a:extLst>
          </p:cNvPr>
          <p:cNvSpPr txBox="1"/>
          <p:nvPr/>
        </p:nvSpPr>
        <p:spPr>
          <a:xfrm>
            <a:off x="1706937" y="2286186"/>
            <a:ext cx="92840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LIT1</a:t>
            </a:r>
            <a:endParaRPr lang="ko-KR" altLang="en-US" sz="5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9DE40EB-FBD7-6886-0D4D-DDD358AB0B25}"/>
              </a:ext>
            </a:extLst>
          </p:cNvPr>
          <p:cNvSpPr txBox="1"/>
          <p:nvPr/>
        </p:nvSpPr>
        <p:spPr>
          <a:xfrm>
            <a:off x="1250155" y="2331925"/>
            <a:ext cx="40669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CSD1</a:t>
            </a:r>
            <a:endParaRPr lang="ko-KR" altLang="en-US" sz="5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6205024-90F1-7DFF-D12C-BB632A4E4363}"/>
              </a:ext>
            </a:extLst>
          </p:cNvPr>
          <p:cNvSpPr txBox="1"/>
          <p:nvPr/>
        </p:nvSpPr>
        <p:spPr>
          <a:xfrm>
            <a:off x="1104899" y="2518979"/>
            <a:ext cx="36433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BD4</a:t>
            </a:r>
            <a:endParaRPr lang="ko-KR" altLang="en-US" sz="5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48FD3655-B0DB-A854-86E7-071E28AF66A9}"/>
              </a:ext>
            </a:extLst>
          </p:cNvPr>
          <p:cNvCxnSpPr>
            <a:cxnSpLocks/>
          </p:cNvCxnSpPr>
          <p:nvPr/>
        </p:nvCxnSpPr>
        <p:spPr>
          <a:xfrm flipH="1">
            <a:off x="1371600" y="2455463"/>
            <a:ext cx="210032" cy="150418"/>
          </a:xfrm>
          <a:prstGeom prst="line">
            <a:avLst/>
          </a:prstGeom>
          <a:ln>
            <a:solidFill>
              <a:srgbClr val="92D050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pic>
        <p:nvPicPr>
          <p:cNvPr id="59" name="Picture 58">
            <a:extLst>
              <a:ext uri="{FF2B5EF4-FFF2-40B4-BE49-F238E27FC236}">
                <a16:creationId xmlns:a16="http://schemas.microsoft.com/office/drawing/2014/main" id="{1D10AF6F-A464-B7CC-8ACD-7ACAFB66C17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634986" y="1454352"/>
            <a:ext cx="797960" cy="988032"/>
          </a:xfrm>
          <a:prstGeom prst="rect">
            <a:avLst/>
          </a:prstGeom>
        </p:spPr>
      </p:pic>
      <p:sp>
        <p:nvSpPr>
          <p:cNvPr id="61" name="TextBox 60">
            <a:extLst>
              <a:ext uri="{FF2B5EF4-FFF2-40B4-BE49-F238E27FC236}">
                <a16:creationId xmlns:a16="http://schemas.microsoft.com/office/drawing/2014/main" id="{B74F78F9-17D7-08AB-88F5-DA3624170079}"/>
              </a:ext>
            </a:extLst>
          </p:cNvPr>
          <p:cNvSpPr txBox="1"/>
          <p:nvPr/>
        </p:nvSpPr>
        <p:spPr>
          <a:xfrm>
            <a:off x="3620170" y="1319756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IC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85F799BE-93D3-4973-947F-295DE5A5AE92}"/>
              </a:ext>
            </a:extLst>
          </p:cNvPr>
          <p:cNvSpPr txBox="1"/>
          <p:nvPr/>
        </p:nvSpPr>
        <p:spPr>
          <a:xfrm>
            <a:off x="3717335" y="2444570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11D4C824-8BBC-BD11-ACB3-BD0D05C609D1}"/>
              </a:ext>
            </a:extLst>
          </p:cNvPr>
          <p:cNvSpPr txBox="1"/>
          <p:nvPr/>
        </p:nvSpPr>
        <p:spPr>
          <a:xfrm>
            <a:off x="4080534" y="2444570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+ 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2031A82C-7F88-523E-855F-E656EC78883D}"/>
              </a:ext>
            </a:extLst>
          </p:cNvPr>
          <p:cNvSpPr txBox="1"/>
          <p:nvPr/>
        </p:nvSpPr>
        <p:spPr>
          <a:xfrm>
            <a:off x="3620170" y="2862292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Lamin-B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6417C4B8-6C00-3EC1-D145-0707D43ED6F9}"/>
              </a:ext>
            </a:extLst>
          </p:cNvPr>
          <p:cNvSpPr txBox="1"/>
          <p:nvPr/>
        </p:nvSpPr>
        <p:spPr>
          <a:xfrm>
            <a:off x="3465390" y="318320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7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73120B3F-158F-758D-7963-C9673DF837A4}"/>
              </a:ext>
            </a:extLst>
          </p:cNvPr>
          <p:cNvSpPr txBox="1"/>
          <p:nvPr/>
        </p:nvSpPr>
        <p:spPr>
          <a:xfrm>
            <a:off x="3712576" y="3984723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4AA61B05-08AB-280D-A166-9DEE55F11175}"/>
              </a:ext>
            </a:extLst>
          </p:cNvPr>
          <p:cNvSpPr txBox="1"/>
          <p:nvPr/>
        </p:nvSpPr>
        <p:spPr>
          <a:xfrm>
            <a:off x="4085296" y="3984723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+ 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B2C1D049-9677-1742-32E1-25621DE5DAE4}"/>
              </a:ext>
            </a:extLst>
          </p:cNvPr>
          <p:cNvSpPr txBox="1"/>
          <p:nvPr/>
        </p:nvSpPr>
        <p:spPr>
          <a:xfrm>
            <a:off x="3466830" y="2983944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6B572B9C-AFDC-31C1-F373-5DF61F0D6EF9}"/>
              </a:ext>
            </a:extLst>
          </p:cNvPr>
          <p:cNvSpPr txBox="1"/>
          <p:nvPr/>
        </p:nvSpPr>
        <p:spPr>
          <a:xfrm>
            <a:off x="4660080" y="2862291"/>
            <a:ext cx="832970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FCSD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AA8D172D-5601-E6C0-1F89-E42E2BA4EC75}"/>
              </a:ext>
            </a:extLst>
          </p:cNvPr>
          <p:cNvSpPr txBox="1"/>
          <p:nvPr/>
        </p:nvSpPr>
        <p:spPr>
          <a:xfrm>
            <a:off x="4757250" y="3984723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3675F9F5-21F8-D67B-5D39-0359FCC4C13A}"/>
              </a:ext>
            </a:extLst>
          </p:cNvPr>
          <p:cNvSpPr txBox="1"/>
          <p:nvPr/>
        </p:nvSpPr>
        <p:spPr>
          <a:xfrm>
            <a:off x="5120444" y="3984723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+ 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A71E228-7A6E-B517-571C-6FC0B6E98454}"/>
              </a:ext>
            </a:extLst>
          </p:cNvPr>
          <p:cNvSpPr txBox="1"/>
          <p:nvPr/>
        </p:nvSpPr>
        <p:spPr>
          <a:xfrm>
            <a:off x="5699990" y="2862283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BD4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00DDFDEB-EC57-F7DE-C211-5B6AB6DC0805}"/>
              </a:ext>
            </a:extLst>
          </p:cNvPr>
          <p:cNvSpPr txBox="1"/>
          <p:nvPr/>
        </p:nvSpPr>
        <p:spPr>
          <a:xfrm>
            <a:off x="5797159" y="3984715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D72658F-1DFF-035A-D3CE-FC68F003FD2B}"/>
              </a:ext>
            </a:extLst>
          </p:cNvPr>
          <p:cNvSpPr txBox="1"/>
          <p:nvPr/>
        </p:nvSpPr>
        <p:spPr>
          <a:xfrm>
            <a:off x="6160357" y="3984715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+ 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2B5E3FEB-E636-63D6-2F86-94F7404C1300}"/>
              </a:ext>
            </a:extLst>
          </p:cNvPr>
          <p:cNvSpPr txBox="1"/>
          <p:nvPr/>
        </p:nvSpPr>
        <p:spPr>
          <a:xfrm>
            <a:off x="4660080" y="1317653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HSPB6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A515F54D-D6A3-0B78-CB2D-B6936B0AD6C8}"/>
              </a:ext>
            </a:extLst>
          </p:cNvPr>
          <p:cNvSpPr txBox="1"/>
          <p:nvPr/>
        </p:nvSpPr>
        <p:spPr>
          <a:xfrm>
            <a:off x="4757250" y="2444848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55389FD9-999F-CEF9-3222-4DD3BD32AAC6}"/>
              </a:ext>
            </a:extLst>
          </p:cNvPr>
          <p:cNvSpPr txBox="1"/>
          <p:nvPr/>
        </p:nvSpPr>
        <p:spPr>
          <a:xfrm>
            <a:off x="5120444" y="2444848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+ 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62AEA0CA-CC71-86DC-FF7A-1FC47B0E7CA0}"/>
              </a:ext>
            </a:extLst>
          </p:cNvPr>
          <p:cNvSpPr txBox="1"/>
          <p:nvPr/>
        </p:nvSpPr>
        <p:spPr>
          <a:xfrm>
            <a:off x="5699990" y="1320026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SLIT1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C868DDE4-1A40-AB1B-38F6-12F28BB4B84D}"/>
              </a:ext>
            </a:extLst>
          </p:cNvPr>
          <p:cNvSpPr txBox="1"/>
          <p:nvPr/>
        </p:nvSpPr>
        <p:spPr>
          <a:xfrm>
            <a:off x="5797159" y="2444840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59987C73-A0A5-C8E7-70FB-393801552E2F}"/>
              </a:ext>
            </a:extLst>
          </p:cNvPr>
          <p:cNvSpPr txBox="1"/>
          <p:nvPr/>
        </p:nvSpPr>
        <p:spPr>
          <a:xfrm>
            <a:off x="6160357" y="2444840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+ 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19B01043-EE7C-B24C-8713-23775CE0D488}"/>
              </a:ext>
            </a:extLst>
          </p:cNvPr>
          <p:cNvSpPr txBox="1"/>
          <p:nvPr/>
        </p:nvSpPr>
        <p:spPr>
          <a:xfrm>
            <a:off x="3613820" y="4669978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MIC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>
            <a:extLst>
              <a:ext uri="{FF2B5EF4-FFF2-40B4-BE49-F238E27FC236}">
                <a16:creationId xmlns:a16="http://schemas.microsoft.com/office/drawing/2014/main" id="{A25E489E-D88E-261D-3227-4378A7748579}"/>
              </a:ext>
            </a:extLst>
          </p:cNvPr>
          <p:cNvSpPr txBox="1"/>
          <p:nvPr/>
        </p:nvSpPr>
        <p:spPr>
          <a:xfrm>
            <a:off x="3710985" y="5794794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>
            <a:extLst>
              <a:ext uri="{FF2B5EF4-FFF2-40B4-BE49-F238E27FC236}">
                <a16:creationId xmlns:a16="http://schemas.microsoft.com/office/drawing/2014/main" id="{AC22E5FB-C1EF-37DB-F1CC-F367EB8027A2}"/>
              </a:ext>
            </a:extLst>
          </p:cNvPr>
          <p:cNvSpPr txBox="1"/>
          <p:nvPr/>
        </p:nvSpPr>
        <p:spPr>
          <a:xfrm>
            <a:off x="4074184" y="5794794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 /AD+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17FA0760-477A-5337-6CA9-BA6461FA1FDE}"/>
              </a:ext>
            </a:extLst>
          </p:cNvPr>
          <p:cNvSpPr txBox="1"/>
          <p:nvPr/>
        </p:nvSpPr>
        <p:spPr>
          <a:xfrm>
            <a:off x="3613820" y="6249983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Demokine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29F7EE5B-D9EA-8179-BF29-8C9FFEDA8C8E}"/>
              </a:ext>
            </a:extLst>
          </p:cNvPr>
          <p:cNvSpPr txBox="1"/>
          <p:nvPr/>
        </p:nvSpPr>
        <p:spPr>
          <a:xfrm>
            <a:off x="3706226" y="7378762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204BFC79-37C9-DB27-90D0-1CAFC0874988}"/>
              </a:ext>
            </a:extLst>
          </p:cNvPr>
          <p:cNvSpPr txBox="1"/>
          <p:nvPr/>
        </p:nvSpPr>
        <p:spPr>
          <a:xfrm>
            <a:off x="4071803" y="7378762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 /AD+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6F371E01-990A-A4D9-B68D-223C8FE288C2}"/>
              </a:ext>
            </a:extLst>
          </p:cNvPr>
          <p:cNvSpPr txBox="1"/>
          <p:nvPr/>
        </p:nvSpPr>
        <p:spPr>
          <a:xfrm>
            <a:off x="4653730" y="6251566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NHRF3</a:t>
            </a:r>
          </a:p>
        </p:txBody>
      </p:sp>
      <p:sp>
        <p:nvSpPr>
          <p:cNvPr id="159" name="TextBox 158">
            <a:extLst>
              <a:ext uri="{FF2B5EF4-FFF2-40B4-BE49-F238E27FC236}">
                <a16:creationId xmlns:a16="http://schemas.microsoft.com/office/drawing/2014/main" id="{C8CF8CE5-EDBD-ED1D-8FF2-C7452FB754E4}"/>
              </a:ext>
            </a:extLst>
          </p:cNvPr>
          <p:cNvSpPr txBox="1"/>
          <p:nvPr/>
        </p:nvSpPr>
        <p:spPr>
          <a:xfrm>
            <a:off x="4750900" y="7378762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284827DA-4A84-E944-7549-EA61110A70BF}"/>
              </a:ext>
            </a:extLst>
          </p:cNvPr>
          <p:cNvSpPr txBox="1"/>
          <p:nvPr/>
        </p:nvSpPr>
        <p:spPr>
          <a:xfrm>
            <a:off x="5114094" y="7378762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 /AD+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BBC9E088-3062-589C-6063-B11FC5AF2905}"/>
              </a:ext>
            </a:extLst>
          </p:cNvPr>
          <p:cNvSpPr txBox="1"/>
          <p:nvPr/>
        </p:nvSpPr>
        <p:spPr>
          <a:xfrm>
            <a:off x="5693640" y="6157897"/>
            <a:ext cx="812776" cy="276999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Selenium-binding protein 1</a:t>
            </a:r>
          </a:p>
        </p:txBody>
      </p:sp>
      <p:sp>
        <p:nvSpPr>
          <p:cNvPr id="165" name="TextBox 164">
            <a:extLst>
              <a:ext uri="{FF2B5EF4-FFF2-40B4-BE49-F238E27FC236}">
                <a16:creationId xmlns:a16="http://schemas.microsoft.com/office/drawing/2014/main" id="{DC794283-6C55-9060-1693-E64C9C4EA7F5}"/>
              </a:ext>
            </a:extLst>
          </p:cNvPr>
          <p:cNvSpPr txBox="1"/>
          <p:nvPr/>
        </p:nvSpPr>
        <p:spPr>
          <a:xfrm>
            <a:off x="5790809" y="7378754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23CF9478-0DEF-B8DC-E36D-A19DEF18273F}"/>
              </a:ext>
            </a:extLst>
          </p:cNvPr>
          <p:cNvSpPr txBox="1"/>
          <p:nvPr/>
        </p:nvSpPr>
        <p:spPr>
          <a:xfrm>
            <a:off x="6154007" y="7378754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 /AD+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9" name="Picture 188">
            <a:extLst>
              <a:ext uri="{FF2B5EF4-FFF2-40B4-BE49-F238E27FC236}">
                <a16:creationId xmlns:a16="http://schemas.microsoft.com/office/drawing/2014/main" id="{5105A707-C747-8B51-A21F-C28CE57FEDF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626377" y="2990526"/>
            <a:ext cx="820323" cy="987604"/>
          </a:xfrm>
          <a:prstGeom prst="rect">
            <a:avLst/>
          </a:prstGeom>
        </p:spPr>
      </p:pic>
      <p:sp>
        <p:nvSpPr>
          <p:cNvPr id="172" name="TextBox 171">
            <a:extLst>
              <a:ext uri="{FF2B5EF4-FFF2-40B4-BE49-F238E27FC236}">
                <a16:creationId xmlns:a16="http://schemas.microsoft.com/office/drawing/2014/main" id="{46DAF8A3-8CF3-A40C-06B8-B35DA3375493}"/>
              </a:ext>
            </a:extLst>
          </p:cNvPr>
          <p:cNvSpPr txBox="1"/>
          <p:nvPr/>
        </p:nvSpPr>
        <p:spPr>
          <a:xfrm>
            <a:off x="4653730" y="4670259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THAP4</a:t>
            </a:r>
          </a:p>
        </p:txBody>
      </p:sp>
      <p:sp>
        <p:nvSpPr>
          <p:cNvPr id="174" name="TextBox 173">
            <a:extLst>
              <a:ext uri="{FF2B5EF4-FFF2-40B4-BE49-F238E27FC236}">
                <a16:creationId xmlns:a16="http://schemas.microsoft.com/office/drawing/2014/main" id="{37A0EA87-33F8-5F6E-51D3-F802D22EDC6B}"/>
              </a:ext>
            </a:extLst>
          </p:cNvPr>
          <p:cNvSpPr txBox="1"/>
          <p:nvPr/>
        </p:nvSpPr>
        <p:spPr>
          <a:xfrm>
            <a:off x="4750900" y="5795072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>
            <a:extLst>
              <a:ext uri="{FF2B5EF4-FFF2-40B4-BE49-F238E27FC236}">
                <a16:creationId xmlns:a16="http://schemas.microsoft.com/office/drawing/2014/main" id="{2DB41F42-7E9A-C30B-42C1-5B9AF85671C1}"/>
              </a:ext>
            </a:extLst>
          </p:cNvPr>
          <p:cNvSpPr txBox="1"/>
          <p:nvPr/>
        </p:nvSpPr>
        <p:spPr>
          <a:xfrm>
            <a:off x="5114094" y="5795072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 /AD+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6FD44BC2-E10D-AB9D-40D2-C64E0ED22732}"/>
              </a:ext>
            </a:extLst>
          </p:cNvPr>
          <p:cNvSpPr txBox="1"/>
          <p:nvPr/>
        </p:nvSpPr>
        <p:spPr>
          <a:xfrm>
            <a:off x="5693640" y="4672632"/>
            <a:ext cx="812776" cy="184666"/>
          </a:xfrm>
          <a:prstGeom prst="rect">
            <a:avLst/>
          </a:prstGeom>
          <a:noFill/>
        </p:spPr>
        <p:txBody>
          <a:bodyPr wrap="square" lIns="0" rIns="0" rtlCol="0">
            <a:spAutoFit/>
          </a:bodyPr>
          <a:lstStyle/>
          <a:p>
            <a:pPr algn="ctr"/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SARP-2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24750580-3AE0-56A4-852F-EC4CA859EC5A}"/>
              </a:ext>
            </a:extLst>
          </p:cNvPr>
          <p:cNvSpPr txBox="1"/>
          <p:nvPr/>
        </p:nvSpPr>
        <p:spPr>
          <a:xfrm>
            <a:off x="5790809" y="5795064"/>
            <a:ext cx="282100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/AD-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E04AD8F6-FF62-9F58-261E-2948CD99BB42}"/>
              </a:ext>
            </a:extLst>
          </p:cNvPr>
          <p:cNvSpPr txBox="1"/>
          <p:nvPr/>
        </p:nvSpPr>
        <p:spPr>
          <a:xfrm>
            <a:off x="6154007" y="5795064"/>
            <a:ext cx="268817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altLang="ko-KR" sz="500" dirty="0">
                <a:latin typeface="Arial" panose="020B0604020202020204" pitchFamily="34" charset="0"/>
                <a:cs typeface="Arial" panose="020B0604020202020204" pitchFamily="34" charset="0"/>
              </a:rPr>
              <a:t>OAβT- /AD+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" name="TextBox 192">
            <a:extLst>
              <a:ext uri="{FF2B5EF4-FFF2-40B4-BE49-F238E27FC236}">
                <a16:creationId xmlns:a16="http://schemas.microsoft.com/office/drawing/2014/main" id="{3FF08989-869A-E1A9-B829-EB1DFF0A5AF8}"/>
              </a:ext>
            </a:extLst>
          </p:cNvPr>
          <p:cNvSpPr txBox="1"/>
          <p:nvPr/>
        </p:nvSpPr>
        <p:spPr>
          <a:xfrm>
            <a:off x="3465390" y="3590403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6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" name="TextBox 193">
            <a:extLst>
              <a:ext uri="{FF2B5EF4-FFF2-40B4-BE49-F238E27FC236}">
                <a16:creationId xmlns:a16="http://schemas.microsoft.com/office/drawing/2014/main" id="{F44C97D9-6083-02F7-E9D7-500D2B6C6FA2}"/>
              </a:ext>
            </a:extLst>
          </p:cNvPr>
          <p:cNvSpPr txBox="1"/>
          <p:nvPr/>
        </p:nvSpPr>
        <p:spPr>
          <a:xfrm>
            <a:off x="3466830" y="3388760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6" name="TextBox 205">
            <a:extLst>
              <a:ext uri="{FF2B5EF4-FFF2-40B4-BE49-F238E27FC236}">
                <a16:creationId xmlns:a16="http://schemas.microsoft.com/office/drawing/2014/main" id="{1D50678C-029C-5C68-0D43-E37CE829D748}"/>
              </a:ext>
            </a:extLst>
          </p:cNvPr>
          <p:cNvSpPr txBox="1"/>
          <p:nvPr/>
        </p:nvSpPr>
        <p:spPr>
          <a:xfrm>
            <a:off x="4510609" y="3743571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2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9" name="TextBox 208">
            <a:extLst>
              <a:ext uri="{FF2B5EF4-FFF2-40B4-BE49-F238E27FC236}">
                <a16:creationId xmlns:a16="http://schemas.microsoft.com/office/drawing/2014/main" id="{3A9818C3-D6F4-560A-51D5-F7144C4F7096}"/>
              </a:ext>
            </a:extLst>
          </p:cNvPr>
          <p:cNvSpPr txBox="1"/>
          <p:nvPr/>
        </p:nvSpPr>
        <p:spPr>
          <a:xfrm>
            <a:off x="4509171" y="3211780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7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6F2F963A-A4B9-CBE6-ECE0-A3201C960EF6}"/>
              </a:ext>
            </a:extLst>
          </p:cNvPr>
          <p:cNvSpPr txBox="1"/>
          <p:nvPr/>
        </p:nvSpPr>
        <p:spPr>
          <a:xfrm>
            <a:off x="4510611" y="347686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5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4" name="TextBox 213">
            <a:extLst>
              <a:ext uri="{FF2B5EF4-FFF2-40B4-BE49-F238E27FC236}">
                <a16:creationId xmlns:a16="http://schemas.microsoft.com/office/drawing/2014/main" id="{9F04D4BA-8C7E-13FF-E198-9BEA8E4B031A}"/>
              </a:ext>
            </a:extLst>
          </p:cNvPr>
          <p:cNvSpPr txBox="1"/>
          <p:nvPr/>
        </p:nvSpPr>
        <p:spPr>
          <a:xfrm>
            <a:off x="5555978" y="3822150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7" name="TextBox 216">
            <a:extLst>
              <a:ext uri="{FF2B5EF4-FFF2-40B4-BE49-F238E27FC236}">
                <a16:creationId xmlns:a16="http://schemas.microsoft.com/office/drawing/2014/main" id="{34F6EC29-45E5-7F88-3A7F-49A8F824CD90}"/>
              </a:ext>
            </a:extLst>
          </p:cNvPr>
          <p:cNvSpPr txBox="1"/>
          <p:nvPr/>
        </p:nvSpPr>
        <p:spPr>
          <a:xfrm>
            <a:off x="5554540" y="3285599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8" name="TextBox 217">
            <a:extLst>
              <a:ext uri="{FF2B5EF4-FFF2-40B4-BE49-F238E27FC236}">
                <a16:creationId xmlns:a16="http://schemas.microsoft.com/office/drawing/2014/main" id="{3B14B09E-E206-E4C4-4D03-03C0C56E4641}"/>
              </a:ext>
            </a:extLst>
          </p:cNvPr>
          <p:cNvSpPr txBox="1"/>
          <p:nvPr/>
        </p:nvSpPr>
        <p:spPr>
          <a:xfrm>
            <a:off x="5555980" y="3014899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5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9" name="TextBox 218">
            <a:extLst>
              <a:ext uri="{FF2B5EF4-FFF2-40B4-BE49-F238E27FC236}">
                <a16:creationId xmlns:a16="http://schemas.microsoft.com/office/drawing/2014/main" id="{7B6A188A-CDAA-D3DD-0FD8-68726D8C675E}"/>
              </a:ext>
            </a:extLst>
          </p:cNvPr>
          <p:cNvSpPr txBox="1"/>
          <p:nvPr/>
        </p:nvSpPr>
        <p:spPr>
          <a:xfrm>
            <a:off x="5554540" y="3552299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38246455-EDB5-B54C-4BE1-9361296384FE}"/>
              </a:ext>
            </a:extLst>
          </p:cNvPr>
          <p:cNvSpPr txBox="1"/>
          <p:nvPr/>
        </p:nvSpPr>
        <p:spPr>
          <a:xfrm>
            <a:off x="4514553" y="2396332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A4D92F54-3F79-841E-3BBD-8EC50AC06453}"/>
              </a:ext>
            </a:extLst>
          </p:cNvPr>
          <p:cNvSpPr txBox="1"/>
          <p:nvPr/>
        </p:nvSpPr>
        <p:spPr>
          <a:xfrm>
            <a:off x="4513115" y="179072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2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2553F02D-2A3D-9738-6CBD-062EF6BB229F}"/>
              </a:ext>
            </a:extLst>
          </p:cNvPr>
          <p:cNvSpPr txBox="1"/>
          <p:nvPr/>
        </p:nvSpPr>
        <p:spPr>
          <a:xfrm>
            <a:off x="4514555" y="1493831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6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6D7563B1-FBCC-36F4-8471-9F2D396D8892}"/>
              </a:ext>
            </a:extLst>
          </p:cNvPr>
          <p:cNvSpPr txBox="1"/>
          <p:nvPr/>
        </p:nvSpPr>
        <p:spPr>
          <a:xfrm>
            <a:off x="4513115" y="2093144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8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0B6A2CD5-1EA8-2824-1F34-105DD510AA3F}"/>
              </a:ext>
            </a:extLst>
          </p:cNvPr>
          <p:cNvSpPr txBox="1"/>
          <p:nvPr/>
        </p:nvSpPr>
        <p:spPr>
          <a:xfrm>
            <a:off x="5554040" y="238658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2A283F97-051D-759F-8475-945A30E79AAA}"/>
              </a:ext>
            </a:extLst>
          </p:cNvPr>
          <p:cNvSpPr txBox="1"/>
          <p:nvPr/>
        </p:nvSpPr>
        <p:spPr>
          <a:xfrm>
            <a:off x="5555480" y="2182565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3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0D4BE3E9-0A12-365B-6A39-34A41A599E5A}"/>
              </a:ext>
            </a:extLst>
          </p:cNvPr>
          <p:cNvSpPr txBox="1"/>
          <p:nvPr/>
        </p:nvSpPr>
        <p:spPr>
          <a:xfrm>
            <a:off x="5554042" y="1765075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FCA02F22-EAB1-B7C3-EFF0-CF230B498F59}"/>
              </a:ext>
            </a:extLst>
          </p:cNvPr>
          <p:cNvSpPr txBox="1"/>
          <p:nvPr/>
        </p:nvSpPr>
        <p:spPr>
          <a:xfrm>
            <a:off x="5555482" y="1551524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2801CF6F-A9F6-F5A1-52C1-870DCBEA6908}"/>
              </a:ext>
            </a:extLst>
          </p:cNvPr>
          <p:cNvSpPr txBox="1"/>
          <p:nvPr/>
        </p:nvSpPr>
        <p:spPr>
          <a:xfrm>
            <a:off x="5555482" y="197062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35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46D82DE6-40F6-D8CC-A5B2-62DC640EBA39}"/>
              </a:ext>
            </a:extLst>
          </p:cNvPr>
          <p:cNvSpPr txBox="1"/>
          <p:nvPr/>
        </p:nvSpPr>
        <p:spPr>
          <a:xfrm>
            <a:off x="3470682" y="1560582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33431B34-CEFF-4B00-94F2-513EE41F5EA3}"/>
              </a:ext>
            </a:extLst>
          </p:cNvPr>
          <p:cNvSpPr txBox="1"/>
          <p:nvPr/>
        </p:nvSpPr>
        <p:spPr>
          <a:xfrm>
            <a:off x="3469242" y="2159896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F719E7B3-29A2-B581-BA06-243D61F9CDDE}"/>
              </a:ext>
            </a:extLst>
          </p:cNvPr>
          <p:cNvSpPr txBox="1"/>
          <p:nvPr/>
        </p:nvSpPr>
        <p:spPr>
          <a:xfrm>
            <a:off x="3470682" y="1863002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4" name="TextBox 253">
            <a:extLst>
              <a:ext uri="{FF2B5EF4-FFF2-40B4-BE49-F238E27FC236}">
                <a16:creationId xmlns:a16="http://schemas.microsoft.com/office/drawing/2014/main" id="{056561BD-D1B4-BDCA-5701-1DCD3E14F34D}"/>
              </a:ext>
            </a:extLst>
          </p:cNvPr>
          <p:cNvSpPr txBox="1"/>
          <p:nvPr/>
        </p:nvSpPr>
        <p:spPr>
          <a:xfrm>
            <a:off x="3463007" y="6713165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2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5" name="TextBox 254">
            <a:extLst>
              <a:ext uri="{FF2B5EF4-FFF2-40B4-BE49-F238E27FC236}">
                <a16:creationId xmlns:a16="http://schemas.microsoft.com/office/drawing/2014/main" id="{06614137-CF10-BD9F-1BCE-406E96C1F976}"/>
              </a:ext>
            </a:extLst>
          </p:cNvPr>
          <p:cNvSpPr txBox="1"/>
          <p:nvPr/>
        </p:nvSpPr>
        <p:spPr>
          <a:xfrm>
            <a:off x="3464447" y="6380552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4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0EA602D9-4914-482F-A988-ACF1DBDA547E}"/>
              </a:ext>
            </a:extLst>
          </p:cNvPr>
          <p:cNvSpPr txBox="1"/>
          <p:nvPr/>
        </p:nvSpPr>
        <p:spPr>
          <a:xfrm>
            <a:off x="3463007" y="7046543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7E8B96C7-2BDC-3FC9-D875-931CA5C4AD5C}"/>
              </a:ext>
            </a:extLst>
          </p:cNvPr>
          <p:cNvSpPr txBox="1"/>
          <p:nvPr/>
        </p:nvSpPr>
        <p:spPr>
          <a:xfrm>
            <a:off x="3468297" y="557298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75EB4810-77F7-AF8C-686B-B1B524351E91}"/>
              </a:ext>
            </a:extLst>
          </p:cNvPr>
          <p:cNvSpPr txBox="1"/>
          <p:nvPr/>
        </p:nvSpPr>
        <p:spPr>
          <a:xfrm>
            <a:off x="3466859" y="4981668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5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F833D9E7-A518-F7B4-C4E5-B444546732B2}"/>
              </a:ext>
            </a:extLst>
          </p:cNvPr>
          <p:cNvSpPr txBox="1"/>
          <p:nvPr/>
        </p:nvSpPr>
        <p:spPr>
          <a:xfrm>
            <a:off x="3468299" y="4782405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6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ACDA5264-9255-8800-89EE-EC555FDCBE7E}"/>
              </a:ext>
            </a:extLst>
          </p:cNvPr>
          <p:cNvSpPr txBox="1"/>
          <p:nvPr/>
        </p:nvSpPr>
        <p:spPr>
          <a:xfrm>
            <a:off x="3466859" y="5374575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3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973083B7-A4B7-ED25-F343-0EDBF8C888FC}"/>
              </a:ext>
            </a:extLst>
          </p:cNvPr>
          <p:cNvSpPr txBox="1"/>
          <p:nvPr/>
        </p:nvSpPr>
        <p:spPr>
          <a:xfrm>
            <a:off x="3468299" y="5177693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B4B272C0-6E26-B431-07F9-16646051A14A}"/>
              </a:ext>
            </a:extLst>
          </p:cNvPr>
          <p:cNvSpPr txBox="1"/>
          <p:nvPr/>
        </p:nvSpPr>
        <p:spPr>
          <a:xfrm>
            <a:off x="4505064" y="7275910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7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5605BCBD-98DA-A4D6-D43E-CC3A7A543D6A}"/>
              </a:ext>
            </a:extLst>
          </p:cNvPr>
          <p:cNvSpPr txBox="1"/>
          <p:nvPr/>
        </p:nvSpPr>
        <p:spPr>
          <a:xfrm>
            <a:off x="4503626" y="677269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8" name="TextBox 267">
            <a:extLst>
              <a:ext uri="{FF2B5EF4-FFF2-40B4-BE49-F238E27FC236}">
                <a16:creationId xmlns:a16="http://schemas.microsoft.com/office/drawing/2014/main" id="{9BCC78AE-E3DE-104D-EE3A-31C977A658D2}"/>
              </a:ext>
            </a:extLst>
          </p:cNvPr>
          <p:cNvSpPr txBox="1"/>
          <p:nvPr/>
        </p:nvSpPr>
        <p:spPr>
          <a:xfrm>
            <a:off x="4505066" y="6606772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1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D50DE2C4-DBFD-F3D6-81F7-C1035CD307F9}"/>
              </a:ext>
            </a:extLst>
          </p:cNvPr>
          <p:cNvSpPr txBox="1"/>
          <p:nvPr/>
        </p:nvSpPr>
        <p:spPr>
          <a:xfrm>
            <a:off x="4503626" y="7103692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8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A4BF0121-162C-0815-8684-E4F409B2751C}"/>
              </a:ext>
            </a:extLst>
          </p:cNvPr>
          <p:cNvSpPr txBox="1"/>
          <p:nvPr/>
        </p:nvSpPr>
        <p:spPr>
          <a:xfrm>
            <a:off x="4505066" y="6940148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9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BD32BA4C-593B-BE86-A9EB-678E12CA6304}"/>
              </a:ext>
            </a:extLst>
          </p:cNvPr>
          <p:cNvSpPr txBox="1"/>
          <p:nvPr/>
        </p:nvSpPr>
        <p:spPr>
          <a:xfrm>
            <a:off x="4508916" y="5589653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C404813B-4B23-59AD-FE81-D2C71CFD747C}"/>
              </a:ext>
            </a:extLst>
          </p:cNvPr>
          <p:cNvSpPr txBox="1"/>
          <p:nvPr/>
        </p:nvSpPr>
        <p:spPr>
          <a:xfrm>
            <a:off x="4505092" y="6437574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22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6DC32D13-097F-B028-3F63-F473A7E1A960}"/>
              </a:ext>
            </a:extLst>
          </p:cNvPr>
          <p:cNvSpPr txBox="1"/>
          <p:nvPr/>
        </p:nvSpPr>
        <p:spPr>
          <a:xfrm>
            <a:off x="4507478" y="5100731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5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36E9D147-2CAB-7358-F2DD-CD37761D636F}"/>
              </a:ext>
            </a:extLst>
          </p:cNvPr>
          <p:cNvSpPr txBox="1"/>
          <p:nvPr/>
        </p:nvSpPr>
        <p:spPr>
          <a:xfrm>
            <a:off x="4508918" y="4934805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6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1938C957-4029-653A-AE43-C1249F067A5C}"/>
              </a:ext>
            </a:extLst>
          </p:cNvPr>
          <p:cNvSpPr txBox="1"/>
          <p:nvPr/>
        </p:nvSpPr>
        <p:spPr>
          <a:xfrm>
            <a:off x="4507478" y="5424583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3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4EDA5BAA-B3B0-191A-E9FD-A009BC3CDADD}"/>
              </a:ext>
            </a:extLst>
          </p:cNvPr>
          <p:cNvSpPr txBox="1"/>
          <p:nvPr/>
        </p:nvSpPr>
        <p:spPr>
          <a:xfrm>
            <a:off x="4508918" y="5258657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23B8B85F-9853-689E-BEAB-A72FA4D0AD2D}"/>
              </a:ext>
            </a:extLst>
          </p:cNvPr>
          <p:cNvSpPr txBox="1"/>
          <p:nvPr/>
        </p:nvSpPr>
        <p:spPr>
          <a:xfrm>
            <a:off x="5546629" y="6682208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9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A4E68C15-67BA-A4E9-FD9F-566F97576A6F}"/>
              </a:ext>
            </a:extLst>
          </p:cNvPr>
          <p:cNvSpPr txBox="1"/>
          <p:nvPr/>
        </p:nvSpPr>
        <p:spPr>
          <a:xfrm>
            <a:off x="5548069" y="6437698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10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CD8769AB-77F1-0018-FA3C-3144570D4C45}"/>
              </a:ext>
            </a:extLst>
          </p:cNvPr>
          <p:cNvSpPr txBox="1"/>
          <p:nvPr/>
        </p:nvSpPr>
        <p:spPr>
          <a:xfrm>
            <a:off x="5546629" y="7165604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7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97169379-3CAD-439E-8D7F-1F78601EC50E}"/>
              </a:ext>
            </a:extLst>
          </p:cNvPr>
          <p:cNvSpPr txBox="1"/>
          <p:nvPr/>
        </p:nvSpPr>
        <p:spPr>
          <a:xfrm>
            <a:off x="5548069" y="6925860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8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E7C7411A-9A33-0ED2-D253-429FCE9318EB}"/>
              </a:ext>
            </a:extLst>
          </p:cNvPr>
          <p:cNvSpPr txBox="1"/>
          <p:nvPr/>
        </p:nvSpPr>
        <p:spPr>
          <a:xfrm>
            <a:off x="5549538" y="5546790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4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95763B83-79B2-FE91-1FFD-220204E6C94F}"/>
              </a:ext>
            </a:extLst>
          </p:cNvPr>
          <p:cNvSpPr txBox="1"/>
          <p:nvPr/>
        </p:nvSpPr>
        <p:spPr>
          <a:xfrm>
            <a:off x="5548100" y="5279323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5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9" name="TextBox 288">
            <a:extLst>
              <a:ext uri="{FF2B5EF4-FFF2-40B4-BE49-F238E27FC236}">
                <a16:creationId xmlns:a16="http://schemas.microsoft.com/office/drawing/2014/main" id="{E1F1AAFF-8DD0-3945-F589-5BBF0826147C}"/>
              </a:ext>
            </a:extLst>
          </p:cNvPr>
          <p:cNvSpPr txBox="1"/>
          <p:nvPr/>
        </p:nvSpPr>
        <p:spPr>
          <a:xfrm>
            <a:off x="5549540" y="5008622"/>
            <a:ext cx="154780" cy="61555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pPr algn="r"/>
            <a:r>
              <a:rPr lang="en-US" altLang="ko-KR" sz="400" dirty="0">
                <a:latin typeface="Arial" panose="020B0604020202020204" pitchFamily="34" charset="0"/>
                <a:cs typeface="Arial" panose="020B0604020202020204" pitchFamily="34" charset="0"/>
              </a:rPr>
              <a:t>600</a:t>
            </a:r>
            <a:endParaRPr lang="ko-KR" altLang="en-US" sz="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3" name="Picture 292">
            <a:extLst>
              <a:ext uri="{FF2B5EF4-FFF2-40B4-BE49-F238E27FC236}">
                <a16:creationId xmlns:a16="http://schemas.microsoft.com/office/drawing/2014/main" id="{2A40EF73-EE27-E1CA-5686-BBEC92625E1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674896" y="1452493"/>
            <a:ext cx="798744" cy="986400"/>
          </a:xfrm>
          <a:prstGeom prst="rect">
            <a:avLst/>
          </a:prstGeom>
        </p:spPr>
      </p:pic>
      <p:pic>
        <p:nvPicPr>
          <p:cNvPr id="295" name="Picture 294">
            <a:extLst>
              <a:ext uri="{FF2B5EF4-FFF2-40B4-BE49-F238E27FC236}">
                <a16:creationId xmlns:a16="http://schemas.microsoft.com/office/drawing/2014/main" id="{64D74F3B-27E0-9A8A-7446-22D4D540782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717381" y="1453905"/>
            <a:ext cx="812410" cy="986400"/>
          </a:xfrm>
          <a:prstGeom prst="rect">
            <a:avLst/>
          </a:prstGeom>
        </p:spPr>
      </p:pic>
      <p:pic>
        <p:nvPicPr>
          <p:cNvPr id="297" name="Picture 296">
            <a:extLst>
              <a:ext uri="{FF2B5EF4-FFF2-40B4-BE49-F238E27FC236}">
                <a16:creationId xmlns:a16="http://schemas.microsoft.com/office/drawing/2014/main" id="{C3266FCC-FEC4-5ECE-A33C-D57FA0C44D1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672232" y="2992265"/>
            <a:ext cx="803288" cy="986400"/>
          </a:xfrm>
          <a:prstGeom prst="rect">
            <a:avLst/>
          </a:prstGeom>
        </p:spPr>
      </p:pic>
      <p:pic>
        <p:nvPicPr>
          <p:cNvPr id="300" name="Picture 299">
            <a:extLst>
              <a:ext uri="{FF2B5EF4-FFF2-40B4-BE49-F238E27FC236}">
                <a16:creationId xmlns:a16="http://schemas.microsoft.com/office/drawing/2014/main" id="{689555E5-EFAC-E518-5E84-30E2FACC35E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5712425" y="2994224"/>
            <a:ext cx="816863" cy="986400"/>
          </a:xfrm>
          <a:prstGeom prst="rect">
            <a:avLst/>
          </a:prstGeom>
        </p:spPr>
      </p:pic>
      <p:sp>
        <p:nvSpPr>
          <p:cNvPr id="301" name="TextBox 300">
            <a:extLst>
              <a:ext uri="{FF2B5EF4-FFF2-40B4-BE49-F238E27FC236}">
                <a16:creationId xmlns:a16="http://schemas.microsoft.com/office/drawing/2014/main" id="{7D059A2F-9C45-1084-B362-4399A86F6819}"/>
              </a:ext>
            </a:extLst>
          </p:cNvPr>
          <p:cNvSpPr txBox="1"/>
          <p:nvPr/>
        </p:nvSpPr>
        <p:spPr>
          <a:xfrm>
            <a:off x="1216280" y="4804576"/>
            <a:ext cx="5509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 err="1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mokine</a:t>
            </a:r>
            <a:endParaRPr lang="ko-KR" altLang="en-US" sz="5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2" name="TextBox 301">
            <a:extLst>
              <a:ext uri="{FF2B5EF4-FFF2-40B4-BE49-F238E27FC236}">
                <a16:creationId xmlns:a16="http://schemas.microsoft.com/office/drawing/2014/main" id="{328E1E5E-1523-2220-7B9D-1726D9B16B09}"/>
              </a:ext>
            </a:extLst>
          </p:cNvPr>
          <p:cNvSpPr txBox="1"/>
          <p:nvPr/>
        </p:nvSpPr>
        <p:spPr>
          <a:xfrm>
            <a:off x="1952150" y="4849125"/>
            <a:ext cx="35528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C-1</a:t>
            </a:r>
            <a:endParaRPr lang="ko-KR" altLang="en-US" sz="5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3" name="TextBox 302">
            <a:extLst>
              <a:ext uri="{FF2B5EF4-FFF2-40B4-BE49-F238E27FC236}">
                <a16:creationId xmlns:a16="http://schemas.microsoft.com/office/drawing/2014/main" id="{15E5B78E-E03D-A964-76E7-A088CE2360E6}"/>
              </a:ext>
            </a:extLst>
          </p:cNvPr>
          <p:cNvSpPr txBox="1"/>
          <p:nvPr/>
        </p:nvSpPr>
        <p:spPr>
          <a:xfrm>
            <a:off x="1952151" y="4953493"/>
            <a:ext cx="7529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HAP4</a:t>
            </a:r>
            <a:endParaRPr lang="ko-KR" altLang="en-US" sz="5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4" name="TextBox 303">
            <a:extLst>
              <a:ext uri="{FF2B5EF4-FFF2-40B4-BE49-F238E27FC236}">
                <a16:creationId xmlns:a16="http://schemas.microsoft.com/office/drawing/2014/main" id="{D1FB82FC-D323-08B4-5778-5C6ACC0C694A}"/>
              </a:ext>
            </a:extLst>
          </p:cNvPr>
          <p:cNvSpPr txBox="1"/>
          <p:nvPr/>
        </p:nvSpPr>
        <p:spPr>
          <a:xfrm>
            <a:off x="1300296" y="5110417"/>
            <a:ext cx="40664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HRF3</a:t>
            </a:r>
            <a:endParaRPr lang="ko-KR" altLang="en-US" sz="5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5" name="TextBox 304">
            <a:extLst>
              <a:ext uri="{FF2B5EF4-FFF2-40B4-BE49-F238E27FC236}">
                <a16:creationId xmlns:a16="http://schemas.microsoft.com/office/drawing/2014/main" id="{04D65894-921E-9C0F-7394-7FC0F7771D69}"/>
              </a:ext>
            </a:extLst>
          </p:cNvPr>
          <p:cNvSpPr txBox="1"/>
          <p:nvPr/>
        </p:nvSpPr>
        <p:spPr>
          <a:xfrm>
            <a:off x="832772" y="5177548"/>
            <a:ext cx="7578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elenium-binding protein 1</a:t>
            </a:r>
            <a:endParaRPr lang="ko-KR" altLang="en-US" sz="500" dirty="0">
              <a:solidFill>
                <a:srgbClr val="00B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6" name="Straight Connector 305">
            <a:extLst>
              <a:ext uri="{FF2B5EF4-FFF2-40B4-BE49-F238E27FC236}">
                <a16:creationId xmlns:a16="http://schemas.microsoft.com/office/drawing/2014/main" id="{65BBD8B5-0A11-D497-BB45-7FD6A497E3E3}"/>
              </a:ext>
            </a:extLst>
          </p:cNvPr>
          <p:cNvCxnSpPr>
            <a:cxnSpLocks/>
          </p:cNvCxnSpPr>
          <p:nvPr/>
        </p:nvCxnSpPr>
        <p:spPr>
          <a:xfrm flipH="1">
            <a:off x="1424122" y="5237299"/>
            <a:ext cx="143904" cy="33992"/>
          </a:xfrm>
          <a:prstGeom prst="line">
            <a:avLst/>
          </a:prstGeom>
          <a:ln>
            <a:solidFill>
              <a:srgbClr val="92D050"/>
            </a:solidFill>
          </a:ln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310" name="TextBox 309">
            <a:extLst>
              <a:ext uri="{FF2B5EF4-FFF2-40B4-BE49-F238E27FC236}">
                <a16:creationId xmlns:a16="http://schemas.microsoft.com/office/drawing/2014/main" id="{B9B46F02-E72D-6FC8-86A4-20A7C869DA26}"/>
              </a:ext>
            </a:extLst>
          </p:cNvPr>
          <p:cNvSpPr txBox="1"/>
          <p:nvPr/>
        </p:nvSpPr>
        <p:spPr>
          <a:xfrm>
            <a:off x="1775617" y="5052836"/>
            <a:ext cx="752948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500" dirty="0">
                <a:solidFill>
                  <a:schemeClr val="accent2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ARP-2</a:t>
            </a:r>
            <a:endParaRPr lang="ko-KR" altLang="en-US" sz="500" dirty="0">
              <a:solidFill>
                <a:schemeClr val="accent2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16" name="Picture 315">
            <a:extLst>
              <a:ext uri="{FF2B5EF4-FFF2-40B4-BE49-F238E27FC236}">
                <a16:creationId xmlns:a16="http://schemas.microsoft.com/office/drawing/2014/main" id="{75C3C8D9-CC21-8873-E18F-8B97C0CE7639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630002" y="4801060"/>
            <a:ext cx="798751" cy="986400"/>
          </a:xfrm>
          <a:prstGeom prst="rect">
            <a:avLst/>
          </a:prstGeom>
        </p:spPr>
      </p:pic>
      <p:pic>
        <p:nvPicPr>
          <p:cNvPr id="318" name="Picture 317">
            <a:extLst>
              <a:ext uri="{FF2B5EF4-FFF2-40B4-BE49-F238E27FC236}">
                <a16:creationId xmlns:a16="http://schemas.microsoft.com/office/drawing/2014/main" id="{166DC79D-F393-22EE-9411-6AFB30B3AF75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668161" y="4803631"/>
            <a:ext cx="809683" cy="986400"/>
          </a:xfrm>
          <a:prstGeom prst="rect">
            <a:avLst/>
          </a:prstGeom>
        </p:spPr>
      </p:pic>
      <p:pic>
        <p:nvPicPr>
          <p:cNvPr id="322" name="Picture 321">
            <a:extLst>
              <a:ext uri="{FF2B5EF4-FFF2-40B4-BE49-F238E27FC236}">
                <a16:creationId xmlns:a16="http://schemas.microsoft.com/office/drawing/2014/main" id="{214FB1FF-D25D-9A63-3F2B-2EB3C55F6D6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708456" y="4802837"/>
            <a:ext cx="820929" cy="986400"/>
          </a:xfrm>
          <a:prstGeom prst="rect">
            <a:avLst/>
          </a:prstGeom>
        </p:spPr>
      </p:pic>
      <p:pic>
        <p:nvPicPr>
          <p:cNvPr id="324" name="Picture 323">
            <a:extLst>
              <a:ext uri="{FF2B5EF4-FFF2-40B4-BE49-F238E27FC236}">
                <a16:creationId xmlns:a16="http://schemas.microsoft.com/office/drawing/2014/main" id="{B2646173-B6AB-526E-9528-168B57A78B87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628636" y="6389238"/>
            <a:ext cx="801951" cy="986400"/>
          </a:xfrm>
          <a:prstGeom prst="rect">
            <a:avLst/>
          </a:prstGeom>
        </p:spPr>
      </p:pic>
      <p:pic>
        <p:nvPicPr>
          <p:cNvPr id="326" name="Picture 325">
            <a:extLst>
              <a:ext uri="{FF2B5EF4-FFF2-40B4-BE49-F238E27FC236}">
                <a16:creationId xmlns:a16="http://schemas.microsoft.com/office/drawing/2014/main" id="{3DA79055-FE04-8C0D-A7DD-90D987EDF728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667574" y="6385081"/>
            <a:ext cx="802549" cy="986400"/>
          </a:xfrm>
          <a:prstGeom prst="rect">
            <a:avLst/>
          </a:prstGeom>
        </p:spPr>
      </p:pic>
      <p:sp>
        <p:nvSpPr>
          <p:cNvPr id="329" name="TextBox 328">
            <a:extLst>
              <a:ext uri="{FF2B5EF4-FFF2-40B4-BE49-F238E27FC236}">
                <a16:creationId xmlns:a16="http://schemas.microsoft.com/office/drawing/2014/main" id="{BDB587DC-6F56-E1B7-FDAD-33EBEEC246B8}"/>
              </a:ext>
            </a:extLst>
          </p:cNvPr>
          <p:cNvSpPr txBox="1"/>
          <p:nvPr/>
        </p:nvSpPr>
        <p:spPr>
          <a:xfrm rot="16200000">
            <a:off x="3189682" y="1845662"/>
            <a:ext cx="4693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RFU</a:t>
            </a:r>
          </a:p>
        </p:txBody>
      </p:sp>
      <p:sp>
        <p:nvSpPr>
          <p:cNvPr id="334" name="TextBox 333">
            <a:extLst>
              <a:ext uri="{FF2B5EF4-FFF2-40B4-BE49-F238E27FC236}">
                <a16:creationId xmlns:a16="http://schemas.microsoft.com/office/drawing/2014/main" id="{60EE5C02-1BD4-5637-69EC-669DEE3DCD62}"/>
              </a:ext>
            </a:extLst>
          </p:cNvPr>
          <p:cNvSpPr txBox="1"/>
          <p:nvPr/>
        </p:nvSpPr>
        <p:spPr>
          <a:xfrm rot="16200000">
            <a:off x="3188900" y="3386563"/>
            <a:ext cx="4693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RFU</a:t>
            </a:r>
          </a:p>
        </p:txBody>
      </p:sp>
      <p:sp>
        <p:nvSpPr>
          <p:cNvPr id="338" name="TextBox 337">
            <a:extLst>
              <a:ext uri="{FF2B5EF4-FFF2-40B4-BE49-F238E27FC236}">
                <a16:creationId xmlns:a16="http://schemas.microsoft.com/office/drawing/2014/main" id="{2D93199A-3545-9CF8-22B6-31C14721BB5B}"/>
              </a:ext>
            </a:extLst>
          </p:cNvPr>
          <p:cNvSpPr txBox="1"/>
          <p:nvPr/>
        </p:nvSpPr>
        <p:spPr>
          <a:xfrm rot="16200000">
            <a:off x="3188900" y="5200307"/>
            <a:ext cx="4693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RFU</a:t>
            </a:r>
          </a:p>
        </p:txBody>
      </p:sp>
      <p:sp>
        <p:nvSpPr>
          <p:cNvPr id="342" name="TextBox 341">
            <a:extLst>
              <a:ext uri="{FF2B5EF4-FFF2-40B4-BE49-F238E27FC236}">
                <a16:creationId xmlns:a16="http://schemas.microsoft.com/office/drawing/2014/main" id="{CA461535-CEB2-1DAA-A4A7-DD832F6DCF89}"/>
              </a:ext>
            </a:extLst>
          </p:cNvPr>
          <p:cNvSpPr txBox="1"/>
          <p:nvPr/>
        </p:nvSpPr>
        <p:spPr>
          <a:xfrm rot="16200000">
            <a:off x="3188900" y="6783859"/>
            <a:ext cx="469383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RFU</a:t>
            </a:r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F0AEABFA-A7B9-4B81-CA67-5FF0367FF73C}"/>
              </a:ext>
            </a:extLst>
          </p:cNvPr>
          <p:cNvSpPr txBox="1"/>
          <p:nvPr/>
        </p:nvSpPr>
        <p:spPr>
          <a:xfrm>
            <a:off x="3049115" y="932209"/>
            <a:ext cx="415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7" name="TextBox 346">
            <a:extLst>
              <a:ext uri="{FF2B5EF4-FFF2-40B4-BE49-F238E27FC236}">
                <a16:creationId xmlns:a16="http://schemas.microsoft.com/office/drawing/2014/main" id="{0F2D1E28-D909-1D51-2FCE-A624089F3473}"/>
              </a:ext>
            </a:extLst>
          </p:cNvPr>
          <p:cNvSpPr txBox="1"/>
          <p:nvPr/>
        </p:nvSpPr>
        <p:spPr>
          <a:xfrm>
            <a:off x="3057990" y="4355520"/>
            <a:ext cx="415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04698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>
            <a:extLst>
              <a:ext uri="{FF2B5EF4-FFF2-40B4-BE49-F238E27FC236}">
                <a16:creationId xmlns:a16="http://schemas.microsoft.com/office/drawing/2014/main" id="{D9C04427-29F5-6E92-2D5B-4A33A88374E2}"/>
              </a:ext>
            </a:extLst>
          </p:cNvPr>
          <p:cNvSpPr txBox="1">
            <a:spLocks/>
          </p:cNvSpPr>
          <p:nvPr/>
        </p:nvSpPr>
        <p:spPr>
          <a:xfrm>
            <a:off x="66676" y="-3245"/>
            <a:ext cx="6772272" cy="9416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ifferentially expressed proteins and associated GO terms across OA</a:t>
            </a:r>
            <a:r>
              <a:rPr lang="el-GR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 and OA</a:t>
            </a:r>
            <a:r>
              <a:rPr lang="el-GR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 Groups in AD and non-AD comparisons. </a:t>
            </a:r>
            <a:endParaRPr lang="ko-KR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71286199-16C4-8466-CE84-BAF952881207}"/>
              </a:ext>
            </a:extLst>
          </p:cNvPr>
          <p:cNvGrpSpPr>
            <a:grpSpLocks noChangeAspect="1"/>
          </p:cNvGrpSpPr>
          <p:nvPr/>
        </p:nvGrpSpPr>
        <p:grpSpPr>
          <a:xfrm>
            <a:off x="2229534" y="1272500"/>
            <a:ext cx="1820857" cy="1892723"/>
            <a:chOff x="6193271" y="1283977"/>
            <a:chExt cx="3775652" cy="3924670"/>
          </a:xfrm>
        </p:grpSpPr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F412140E-B46D-FA11-21F5-635AEE0DD379}"/>
                </a:ext>
              </a:extLst>
            </p:cNvPr>
            <p:cNvSpPr/>
            <p:nvPr/>
          </p:nvSpPr>
          <p:spPr>
            <a:xfrm>
              <a:off x="6954982" y="1653309"/>
              <a:ext cx="2225963" cy="2115127"/>
            </a:xfrm>
            <a:prstGeom prst="ellipse">
              <a:avLst/>
            </a:prstGeom>
            <a:solidFill>
              <a:schemeClr val="accent1">
                <a:alpha val="30000"/>
              </a:schemeClr>
            </a:solidFill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ko-KR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Oval 22">
              <a:extLst>
                <a:ext uri="{FF2B5EF4-FFF2-40B4-BE49-F238E27FC236}">
                  <a16:creationId xmlns:a16="http://schemas.microsoft.com/office/drawing/2014/main" id="{E51A0D1A-0D41-F502-684D-51AB83E884F3}"/>
                </a:ext>
              </a:extLst>
            </p:cNvPr>
            <p:cNvSpPr/>
            <p:nvPr/>
          </p:nvSpPr>
          <p:spPr>
            <a:xfrm>
              <a:off x="6193271" y="2739447"/>
              <a:ext cx="2225963" cy="2115127"/>
            </a:xfrm>
            <a:prstGeom prst="ellipse">
              <a:avLst/>
            </a:prstGeom>
            <a:solidFill>
              <a:srgbClr val="C00000">
                <a:alpha val="30000"/>
              </a:srgbClr>
            </a:solidFill>
          </p:spPr>
          <p:style>
            <a:lnRef idx="2">
              <a:schemeClr val="accent4">
                <a:shade val="15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ko-KR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Oval 23">
              <a:extLst>
                <a:ext uri="{FF2B5EF4-FFF2-40B4-BE49-F238E27FC236}">
                  <a16:creationId xmlns:a16="http://schemas.microsoft.com/office/drawing/2014/main" id="{6E43C2B7-BCB0-E733-96AC-D30866CD6D26}"/>
                </a:ext>
              </a:extLst>
            </p:cNvPr>
            <p:cNvSpPr/>
            <p:nvPr/>
          </p:nvSpPr>
          <p:spPr>
            <a:xfrm>
              <a:off x="7742960" y="2739447"/>
              <a:ext cx="2225963" cy="2115127"/>
            </a:xfrm>
            <a:prstGeom prst="ellipse">
              <a:avLst/>
            </a:prstGeom>
            <a:solidFill>
              <a:srgbClr val="FFFF00">
                <a:alpha val="30000"/>
              </a:srgbClr>
            </a:solidFill>
          </p:spPr>
          <p:style>
            <a:lnRef idx="2">
              <a:schemeClr val="accent6">
                <a:shade val="15000"/>
              </a:schemeClr>
            </a:lnRef>
            <a:fillRef idx="1">
              <a:schemeClr val="accent6"/>
            </a:fillRef>
            <a:effectRef idx="0">
              <a:schemeClr val="accent6"/>
            </a:effectRef>
            <a:fontRef idx="minor">
              <a:schemeClr val="lt1"/>
            </a:fontRef>
          </p:style>
          <p:txBody>
            <a:bodyPr lIns="0" tIns="0" rIns="0" bIns="0" rtlCol="0" anchor="ctr"/>
            <a:lstStyle/>
            <a:p>
              <a:pPr algn="ctr"/>
              <a:endParaRPr lang="ko-KR" altLang="en-US" sz="10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66E793A9-194E-4B3A-BFE1-48D9522DBCA4}"/>
                </a:ext>
              </a:extLst>
            </p:cNvPr>
            <p:cNvSpPr txBox="1"/>
            <p:nvPr/>
          </p:nvSpPr>
          <p:spPr>
            <a:xfrm>
              <a:off x="7218994" y="1283977"/>
              <a:ext cx="1806189" cy="335052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OA</a:t>
              </a:r>
              <a:r>
                <a:rPr lang="el-GR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+/AD+ 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67C351F6-DA20-BC0F-F886-126E5A483DC1}"/>
                </a:ext>
              </a:extLst>
            </p:cNvPr>
            <p:cNvSpPr txBox="1"/>
            <p:nvPr/>
          </p:nvSpPr>
          <p:spPr>
            <a:xfrm>
              <a:off x="6193271" y="4873595"/>
              <a:ext cx="2109619" cy="335052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OA</a:t>
              </a:r>
              <a:r>
                <a:rPr lang="el-GR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+/AD- 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2DFF24B0-9F0F-1ABA-F83F-2FC71EAE0AA2}"/>
                </a:ext>
              </a:extLst>
            </p:cNvPr>
            <p:cNvSpPr txBox="1"/>
            <p:nvPr/>
          </p:nvSpPr>
          <p:spPr>
            <a:xfrm>
              <a:off x="7997559" y="4873595"/>
              <a:ext cx="1935944" cy="335052"/>
            </a:xfrm>
            <a:prstGeom prst="rect">
              <a:avLst/>
            </a:prstGeom>
            <a:noFill/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OA</a:t>
              </a:r>
              <a:r>
                <a:rPr lang="el-GR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T-/AD+ </a:t>
              </a:r>
              <a:endParaRPr lang="ko-KR" altLang="en-US" sz="105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BCBD8A6-4B23-052A-CB2A-53CE818A58FF}"/>
                </a:ext>
              </a:extLst>
            </p:cNvPr>
            <p:cNvSpPr txBox="1"/>
            <p:nvPr/>
          </p:nvSpPr>
          <p:spPr>
            <a:xfrm>
              <a:off x="7806858" y="3285715"/>
              <a:ext cx="523009" cy="3190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19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A4B4C2C-1456-EFE1-B9B0-D864AEE22DCA}"/>
                </a:ext>
              </a:extLst>
            </p:cNvPr>
            <p:cNvSpPr txBox="1"/>
            <p:nvPr/>
          </p:nvSpPr>
          <p:spPr>
            <a:xfrm>
              <a:off x="7225832" y="3009061"/>
              <a:ext cx="523009" cy="3190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47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2081395B-3EFD-8E0B-6812-E530BD822CDA}"/>
                </a:ext>
              </a:extLst>
            </p:cNvPr>
            <p:cNvSpPr txBox="1"/>
            <p:nvPr/>
          </p:nvSpPr>
          <p:spPr>
            <a:xfrm>
              <a:off x="8356199" y="3009061"/>
              <a:ext cx="523009" cy="3190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6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F75699A4-0259-824F-A36A-E44FB4B29C22}"/>
                </a:ext>
              </a:extLst>
            </p:cNvPr>
            <p:cNvSpPr txBox="1"/>
            <p:nvPr/>
          </p:nvSpPr>
          <p:spPr>
            <a:xfrm>
              <a:off x="7820023" y="3891455"/>
              <a:ext cx="523009" cy="3190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7AE6054-CA0F-F243-7C7B-5377D75379AE}"/>
                </a:ext>
              </a:extLst>
            </p:cNvPr>
            <p:cNvSpPr txBox="1"/>
            <p:nvPr/>
          </p:nvSpPr>
          <p:spPr>
            <a:xfrm>
              <a:off x="7658098" y="2159305"/>
              <a:ext cx="895354" cy="3190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29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2B2A4DC2-36F6-FD18-DF0D-931AB6F32CC9}"/>
                </a:ext>
              </a:extLst>
            </p:cNvPr>
            <p:cNvSpPr txBox="1"/>
            <p:nvPr/>
          </p:nvSpPr>
          <p:spPr>
            <a:xfrm>
              <a:off x="6724647" y="3703135"/>
              <a:ext cx="895354" cy="3190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220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580E2981-EC12-D3C7-CCE7-E4DCED630E23}"/>
                </a:ext>
              </a:extLst>
            </p:cNvPr>
            <p:cNvSpPr txBox="1"/>
            <p:nvPr/>
          </p:nvSpPr>
          <p:spPr>
            <a:xfrm>
              <a:off x="8543922" y="3703135"/>
              <a:ext cx="895354" cy="319096"/>
            </a:xfrm>
            <a:prstGeom prst="rect">
              <a:avLst/>
            </a:prstGeom>
            <a:noFill/>
          </p:spPr>
          <p:txBody>
            <a:bodyPr wrap="square" lIns="0" tIns="0" rIns="0" bIns="0" rtlCol="0">
              <a:spAutoFit/>
            </a:bodyPr>
            <a:lstStyle/>
            <a:p>
              <a:pPr algn="ctr"/>
              <a:r>
                <a:rPr lang="en-US" altLang="ko-KR" sz="1000" dirty="0">
                  <a:latin typeface="Arial" panose="020B0604020202020204" pitchFamily="34" charset="0"/>
                  <a:cs typeface="Arial" panose="020B0604020202020204" pitchFamily="34" charset="0"/>
                </a:rPr>
                <a:t>357</a:t>
              </a:r>
              <a:endParaRPr lang="ko-KR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9C0B7E89-C9F9-FE5D-6CDF-36AFD9118375}"/>
              </a:ext>
            </a:extLst>
          </p:cNvPr>
          <p:cNvSpPr txBox="1"/>
          <p:nvPr/>
        </p:nvSpPr>
        <p:spPr>
          <a:xfrm>
            <a:off x="1982954" y="1111050"/>
            <a:ext cx="4156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D8D2236-9447-7EE1-7565-C71F5DE0798D}"/>
              </a:ext>
            </a:extLst>
          </p:cNvPr>
          <p:cNvSpPr txBox="1"/>
          <p:nvPr/>
        </p:nvSpPr>
        <p:spPr>
          <a:xfrm>
            <a:off x="25245" y="5865667"/>
            <a:ext cx="681370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Venn diagram of number of significantly differentially expressed (p&lt;0.05) proteins from different group comparisons 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)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op GO terms changed in OA</a:t>
            </a:r>
            <a:r>
              <a:rPr lang="el-GR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/AD+ compared to OA</a:t>
            </a:r>
            <a:r>
              <a:rPr lang="el-GR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/AD+ 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C) 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op GO terms changed in OA</a:t>
            </a:r>
            <a:r>
              <a:rPr lang="el-GR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/AD- compared to OA</a:t>
            </a:r>
            <a:r>
              <a:rPr lang="el-GR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/AD-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" name="Group 12">
            <a:extLst>
              <a:ext uri="{FF2B5EF4-FFF2-40B4-BE49-F238E27FC236}">
                <a16:creationId xmlns:a16="http://schemas.microsoft.com/office/drawing/2014/main" id="{CC0982B0-8278-BBB0-3E4F-4E3E8A6A348B}"/>
              </a:ext>
            </a:extLst>
          </p:cNvPr>
          <p:cNvGrpSpPr/>
          <p:nvPr/>
        </p:nvGrpSpPr>
        <p:grpSpPr>
          <a:xfrm>
            <a:off x="-15409" y="3540918"/>
            <a:ext cx="3391634" cy="2174278"/>
            <a:chOff x="-15409" y="3540918"/>
            <a:chExt cx="3391634" cy="2174278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A8726A4D-9794-43D7-5562-83C281E47C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6713"/>
            <a:stretch/>
          </p:blipFill>
          <p:spPr>
            <a:xfrm>
              <a:off x="66675" y="3807071"/>
              <a:ext cx="3309550" cy="190812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C374AF79-AC0C-F2A1-B32E-DC25A671C661}"/>
                </a:ext>
              </a:extLst>
            </p:cNvPr>
            <p:cNvSpPr txBox="1"/>
            <p:nvPr/>
          </p:nvSpPr>
          <p:spPr>
            <a:xfrm>
              <a:off x="-15409" y="3540918"/>
              <a:ext cx="4156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81EE4AB-3DF3-37A3-B753-BF044B5B959F}"/>
                </a:ext>
              </a:extLst>
            </p:cNvPr>
            <p:cNvSpPr txBox="1"/>
            <p:nvPr/>
          </p:nvSpPr>
          <p:spPr>
            <a:xfrm>
              <a:off x="464146" y="3634016"/>
              <a:ext cx="2473485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ene Ontology Term </a:t>
              </a:r>
            </a:p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(OA</a:t>
              </a:r>
              <a:r>
                <a:rPr lang="el-GR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+/AD+ vs OA</a:t>
              </a:r>
              <a:r>
                <a:rPr lang="el-GR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-/AD+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Group 13">
            <a:extLst>
              <a:ext uri="{FF2B5EF4-FFF2-40B4-BE49-F238E27FC236}">
                <a16:creationId xmlns:a16="http://schemas.microsoft.com/office/drawing/2014/main" id="{4D872A89-299C-89B2-01FF-A83756F15019}"/>
              </a:ext>
            </a:extLst>
          </p:cNvPr>
          <p:cNvGrpSpPr/>
          <p:nvPr/>
        </p:nvGrpSpPr>
        <p:grpSpPr>
          <a:xfrm>
            <a:off x="3246925" y="3634018"/>
            <a:ext cx="3592024" cy="2097764"/>
            <a:chOff x="3246925" y="3634018"/>
            <a:chExt cx="3592024" cy="2097764"/>
          </a:xfrm>
        </p:grpSpPr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87B136B3-E632-35DA-C221-52C199BF6C8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7106"/>
            <a:stretch/>
          </p:blipFill>
          <p:spPr>
            <a:xfrm>
              <a:off x="3394946" y="3806155"/>
              <a:ext cx="3444003" cy="1925627"/>
            </a:xfrm>
            <a:prstGeom prst="rect">
              <a:avLst/>
            </a:prstGeom>
          </p:spPr>
        </p:pic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25EC6E8C-FCF1-D811-432D-BAFC83488985}"/>
                </a:ext>
              </a:extLst>
            </p:cNvPr>
            <p:cNvSpPr txBox="1"/>
            <p:nvPr/>
          </p:nvSpPr>
          <p:spPr>
            <a:xfrm>
              <a:off x="3246925" y="3645095"/>
              <a:ext cx="4156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B6830F4-002A-174D-30D3-0E9A3484C921}"/>
                </a:ext>
              </a:extLst>
            </p:cNvPr>
            <p:cNvSpPr txBox="1"/>
            <p:nvPr/>
          </p:nvSpPr>
          <p:spPr>
            <a:xfrm>
              <a:off x="3528535" y="3634018"/>
              <a:ext cx="3027024" cy="43088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Gene Ontology Term</a:t>
              </a:r>
            </a:p>
            <a:p>
              <a:pPr algn="ctr"/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 (OA</a:t>
              </a:r>
              <a:r>
                <a:rPr lang="el-GR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+/AD- vs OA</a:t>
              </a:r>
              <a:r>
                <a:rPr lang="el-GR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altLang="ko-K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T-/AD-)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277487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21A64ED0-3E3C-D2EF-24FD-9424B31A4E46}"/>
              </a:ext>
            </a:extLst>
          </p:cNvPr>
          <p:cNvSpPr/>
          <p:nvPr/>
        </p:nvSpPr>
        <p:spPr>
          <a:xfrm>
            <a:off x="132443" y="853843"/>
            <a:ext cx="6602535" cy="2964876"/>
          </a:xfrm>
          <a:prstGeom prst="rect">
            <a:avLst/>
          </a:prstGeom>
          <a:solidFill>
            <a:schemeClr val="accent1">
              <a:alpha val="57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50">
              <a:solidFill>
                <a:schemeClr val="tx1"/>
              </a:solidFill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C042F1E8-310A-F57A-654A-0B4403D37141}"/>
              </a:ext>
            </a:extLst>
          </p:cNvPr>
          <p:cNvSpPr/>
          <p:nvPr/>
        </p:nvSpPr>
        <p:spPr>
          <a:xfrm>
            <a:off x="79663" y="2501391"/>
            <a:ext cx="4121961" cy="5982321"/>
          </a:xfrm>
          <a:prstGeom prst="rect">
            <a:avLst/>
          </a:prstGeom>
          <a:solidFill>
            <a:srgbClr val="FF0000">
              <a:alpha val="60000"/>
            </a:srgbClr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 dirty="0">
              <a:solidFill>
                <a:schemeClr val="tx1"/>
              </a:solidFill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31D2ECAE-23E4-E82C-737C-0B150D9AE683}"/>
              </a:ext>
            </a:extLst>
          </p:cNvPr>
          <p:cNvSpPr/>
          <p:nvPr/>
        </p:nvSpPr>
        <p:spPr>
          <a:xfrm>
            <a:off x="2961134" y="2543156"/>
            <a:ext cx="3830365" cy="5980324"/>
          </a:xfrm>
          <a:prstGeom prst="rect">
            <a:avLst/>
          </a:prstGeom>
          <a:solidFill>
            <a:schemeClr val="accent4">
              <a:alpha val="60000"/>
            </a:schemeClr>
          </a:solidFill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400" dirty="0">
              <a:solidFill>
                <a:schemeClr val="tx1"/>
              </a:solidFill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D3BACBE-B2A2-BBED-B83B-620F08D30545}"/>
              </a:ext>
            </a:extLst>
          </p:cNvPr>
          <p:cNvSpPr txBox="1"/>
          <p:nvPr/>
        </p:nvSpPr>
        <p:spPr>
          <a:xfrm>
            <a:off x="126300" y="855921"/>
            <a:ext cx="6599257" cy="16312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LFA-1 alpha-L chain, UBTD2, NHRF3, RFESD, p27Kip1, Carbonic anhydrase III, Carbonic anhydrase I, SEM3B, CETP, MYPC1, LRP12, AGGF1, SOD3, SUN3, MXI1, MCM6, FANCL, 4F2:CD, PARP:BRCT domain, CSF-1, IL27B, CO1A1:C-term </a:t>
            </a:r>
            <a:r>
              <a:rPr lang="en-US" altLang="ko-KR" sz="1000" dirty="0" err="1"/>
              <a:t>propeptide</a:t>
            </a:r>
            <a:r>
              <a:rPr lang="en-US" altLang="ko-KR" sz="1000" dirty="0"/>
              <a:t>, TITIN, Testican-1, HEM3, CYGB, DHX8, APC7, IP3KC, CYH2, ST1B1, SGF29, CCD51, SAP18, PAXI1, FSTL1, MAZ, KIN17, LA:RRM, C9, CNTFR alpha, MIP-5, SCP2D, RET7, PAP1, </a:t>
            </a:r>
            <a:r>
              <a:rPr lang="en-US" altLang="ko-KR" sz="1000" dirty="0" err="1"/>
              <a:t>IgJ</a:t>
            </a:r>
            <a:r>
              <a:rPr lang="en-US" altLang="ko-KR" sz="1000" dirty="0"/>
              <a:t>, FABPA, SAP3, kallikrein 14, PACAP, Caspase-14, BLVRB, Annexin III, SELH, KREM1, UBD, CLIC2, TCL1B, PSD10, Tissue transglutaminase, IRF4, CEBPG, MEOX1, BUD31, PHOP1, IL-35, I17RE, MLRS, SF3B6, SYT1, RGS14, SAHH, NDP, BTG4, CRBL2, E2F5, PHF11, FZD1, SSNA1, COA7, RASF5, K1143, KLH41, TRI72, ABEC2, PKHB1, CFDP1, SH3K1, HDAC4, PKHM2, SOX-9, EMAL2, Macrophage mannose receptor, </a:t>
            </a:r>
            <a:r>
              <a:rPr lang="en-US" altLang="ko-KR" sz="1000" dirty="0" err="1"/>
              <a:t>suPAR</a:t>
            </a:r>
            <a:r>
              <a:rPr lang="en-US" altLang="ko-KR" sz="1000" dirty="0"/>
              <a:t>, IGFBP-5, C9, ULBP-1, </a:t>
            </a:r>
            <a:r>
              <a:rPr lang="en-US" altLang="ko-KR" sz="1000" dirty="0" err="1"/>
              <a:t>TrATPase</a:t>
            </a:r>
            <a:r>
              <a:rPr lang="en-US" altLang="ko-KR" sz="1000" dirty="0"/>
              <a:t>, Kallikrein 7, Catalase, LEAP-1, a1-Antitrypsin, CHL1, CSF-1, Spondin-1, SPARCL1, Hemoglobin, MIS, </a:t>
            </a:r>
            <a:r>
              <a:rPr lang="en-US" altLang="ko-KR" sz="1000" dirty="0" err="1"/>
              <a:t>Elafin</a:t>
            </a:r>
            <a:r>
              <a:rPr lang="en-US" altLang="ko-KR" sz="1000" dirty="0"/>
              <a:t>, CSK21, calgranulin B, Spondin-1, NOE1, SOST, PLTP, PLUNC, PCDGC, CD2, CC90B, DLG3, RSPO3, kallikrein 14, YTDC1, </a:t>
            </a:r>
            <a:r>
              <a:rPr lang="en-US" altLang="ko-KR" sz="1000" dirty="0" err="1"/>
              <a:t>PARP:region</a:t>
            </a:r>
            <a:r>
              <a:rPr lang="en-US" altLang="ko-KR" sz="1000" dirty="0"/>
              <a:t> 1, NR1H4, PLXA1, SHPS1, JPH4, WFD13, Activin RIIB, CG069, ACTN2, Cyclin H</a:t>
            </a:r>
            <a:endParaRPr lang="ko-KR" altLang="en-US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75650C8F-ED68-A500-9EAE-E6C869673EE7}"/>
              </a:ext>
            </a:extLst>
          </p:cNvPr>
          <p:cNvSpPr txBox="1"/>
          <p:nvPr/>
        </p:nvSpPr>
        <p:spPr>
          <a:xfrm>
            <a:off x="65384" y="3816577"/>
            <a:ext cx="2895750" cy="47089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VTM2L, Angiopoietin-2, Sonic Hedgehog, TGF-b R III, ZAP70, AUGN, TRIL:ECD, LRRT4:ECD, ART4, TR:CD, ERO1A, VAMP8, KI3L3:ECD, CA226, MXRA7, PACAP-27, </a:t>
            </a:r>
            <a:r>
              <a:rPr lang="en-US" altLang="ko-KR" sz="1000" dirty="0" err="1"/>
              <a:t>CgA</a:t>
            </a:r>
            <a:r>
              <a:rPr lang="en-US" altLang="ko-KR" sz="1000" dirty="0"/>
              <a:t>, TMEM9:CD, COX6C, TIM-1, LYPD1, </a:t>
            </a:r>
            <a:r>
              <a:rPr lang="en-US" altLang="ko-KR" sz="1000" dirty="0" err="1"/>
              <a:t>Fas</a:t>
            </a:r>
            <a:r>
              <a:rPr lang="en-US" altLang="ko-KR" sz="1000" dirty="0"/>
              <a:t> (soluble), TIGIT, S22AG, GUC1A, MXRA8:ECD, DHX9, C99L2, MUC1:region 1, NDUB4, ZPBP2, GPR64, HHIP, Desmocollin-1, TLR4, ANGL1:C-term, </a:t>
            </a:r>
            <a:r>
              <a:rPr lang="en-US" altLang="ko-KR" sz="1000" dirty="0" err="1"/>
              <a:t>CgA</a:t>
            </a:r>
            <a:r>
              <a:rPr lang="en-US" altLang="ko-KR" sz="1000" dirty="0"/>
              <a:t>, ATF6A, HE4, CD38, RORG, EMC1, </a:t>
            </a:r>
            <a:r>
              <a:rPr lang="en-US" altLang="ko-KR" sz="1000" dirty="0" err="1"/>
              <a:t>Desmin</a:t>
            </a:r>
            <a:r>
              <a:rPr lang="en-US" altLang="ko-KR" sz="1000" dirty="0"/>
              <a:t>, STAP1, TPPP2, TEAD3, p107, AXIN2, UCR6, </a:t>
            </a:r>
            <a:r>
              <a:rPr lang="en-US" altLang="ko-KR" sz="1000" dirty="0" err="1"/>
              <a:t>Lumican</a:t>
            </a:r>
            <a:r>
              <a:rPr lang="en-US" altLang="ko-KR" sz="1000" dirty="0"/>
              <a:t>, FLRT3:ECD, p130, Angiopoietin-2, Factor D, IL-5 Ra, C1-Esterase Inhibitor, QOR, Carbonic Anhydrase IV, IGFBP-6, DDX46, T185A, LSHR, PACN3, </a:t>
            </a:r>
            <a:r>
              <a:rPr lang="en-US" altLang="ko-KR" sz="1000" dirty="0" err="1"/>
              <a:t>Azurocidin</a:t>
            </a:r>
            <a:r>
              <a:rPr lang="en-US" altLang="ko-KR" sz="1000" dirty="0"/>
              <a:t>, ANTR2, SLIT1, INHBC, WIF-1, CD9, SIR3, RPP30, PPR1A, Caspase-8, Afamin, HEM6, Sperm protein 17, GLCM, SH21B, ISK4, GIMA6, PT117, PDCD6, KLOTB, </a:t>
            </a:r>
            <a:r>
              <a:rPr lang="en-US" altLang="ko-KR" sz="1000" dirty="0" err="1"/>
              <a:t>ihh</a:t>
            </a:r>
            <a:r>
              <a:rPr lang="en-US" altLang="ko-KR" sz="1000" dirty="0"/>
              <a:t>, ADA, Integrin aVb3, GBP5, DPYL4, TPPP3, GRIK2, CQ10A, CLUL1, GGT5, METRL, LIRA1, FBLN7, F86B1, FOSL2, HHLA3, PL8L1, PACR, SPI1, ST6B1, TAF12, THA11, MEOX2, Caspase-10:region 2, Beta-</a:t>
            </a:r>
            <a:r>
              <a:rPr lang="en-US" altLang="ko-KR" sz="1000" dirty="0" err="1"/>
              <a:t>dystroglycan</a:t>
            </a:r>
            <a:r>
              <a:rPr lang="en-US" altLang="ko-KR" sz="1000" dirty="0"/>
              <a:t>, NAR5, TRI62, ROGDI, FNDC8, ERGI1, PADI1, SLNL1, ACSS3, ASNS, C5, CYBR1, GLPK5, RAD18, APEX2, NRDC, CAD23, DYR1A, RPGF1, Factor D, IL-19, BAFF, URB, IGFBP-7, Carbonic anhydrase 6, Endothelin-converting enzyme 1:ECD, Factor H, MMP-2, </a:t>
            </a:r>
            <a:r>
              <a:rPr lang="en-US" altLang="ko-KR" sz="1000" dirty="0" err="1"/>
              <a:t>Collectin</a:t>
            </a:r>
            <a:r>
              <a:rPr lang="en-US" altLang="ko-KR" sz="1000" dirty="0"/>
              <a:t> Kidney 1, Afamin, TSG-6, cGMP-stimulated PDE, IL-17 RC, Tenascin-X, CI061, b-NGF, Gastrin-releasing peptide, NELL2, PCOC2, NELL1, CV015, NFASC, NKG2E:CD, UGT 1A6, FJX1, SIA7E, SYT8, LARGE, CD3E, PLD5, OPG, NRX2B, NEO1, TFPI -2, SFRP4, REG3G, MPZL2, MGT4A</a:t>
            </a:r>
            <a:endParaRPr lang="ko-KR" altLang="en-US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3687FDF8-5D14-2A72-3553-C053DAC62460}"/>
              </a:ext>
            </a:extLst>
          </p:cNvPr>
          <p:cNvSpPr txBox="1"/>
          <p:nvPr/>
        </p:nvSpPr>
        <p:spPr>
          <a:xfrm>
            <a:off x="4195646" y="3803811"/>
            <a:ext cx="2548752" cy="45550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CAZA1, MIA, WIF-1, </a:t>
            </a:r>
            <a:r>
              <a:rPr lang="en-US" altLang="ko-KR" sz="1000" dirty="0" err="1"/>
              <a:t>vWF</a:t>
            </a:r>
            <a:r>
              <a:rPr lang="en-US" altLang="ko-KR" sz="1000" dirty="0"/>
              <a:t>, ADAMTS-5, DNSL2, LRP11, N-terminal pro-BNP, DJB12, ROR1, FAM3B, EGFL9, Lectin, mannose-binding 2, DYR, SULT 1E, PEBB, Mcl-1, PUF60, DKK3, C1QR1, PCOC1, ARLY, filamin A:CH1, HS71L, Apo F, IRF2, FLRT2, CATC, Cardiotrophin-1, IL-15 Ra, MAGI2, </a:t>
            </a:r>
            <a:r>
              <a:rPr lang="en-US" altLang="ko-KR" sz="1000" dirty="0" err="1"/>
              <a:t>Granulysin</a:t>
            </a:r>
            <a:r>
              <a:rPr lang="en-US" altLang="ko-KR" sz="1000" dirty="0"/>
              <a:t>, MYL6B, MOCS3, Ribonuclease UK114, Secretagogin, CPLX2, UNC5B, </a:t>
            </a:r>
            <a:r>
              <a:rPr lang="en-US" altLang="ko-KR" sz="1000" dirty="0" err="1"/>
              <a:t>OTCase</a:t>
            </a:r>
            <a:r>
              <a:rPr lang="en-US" altLang="ko-KR" sz="1000" dirty="0"/>
              <a:t>, a1-Microglobulin, Aminopeptidase N, SAA-4, NRX3A, HD-5, ATL1, TEBP, VPS28 protein homolog, THIK, SRA1, TRIA1, ARF5, PPIG, </a:t>
            </a:r>
            <a:r>
              <a:rPr lang="en-US" altLang="ko-KR" sz="1000" dirty="0" err="1"/>
              <a:t>Chondrocalcin</a:t>
            </a:r>
            <a:r>
              <a:rPr lang="en-US" altLang="ko-KR" sz="1000" dirty="0"/>
              <a:t>, KI3L1, SLIT2, GNAI1, GLYAT, SUMO2, ASB9, LTB4DH, MYL4, DPYS, MED20, IFT20, IRPL1, HNP-3, MER, FZD7, EIF1, RP9, FA84B, UBE2W, TMED9, HYES, BT3A2, URM1, CO5A1, CR054, PHYD1, RIP, EPHA6, FZD2, FZD9, BT3A3, GBRAP, IGFBP-2, UNC5B, LTK, ARRD5, F118A, GAS2, SAST, GIMD1, STA10, PRR15, EHD2, CEP76, DCC1, CK049, EF1G, THAP4, TCAL5, CAN13, OGFR, PCDH1, SAC2, MPP5, FTO, PGM5, DPP8, AIM2, Cystatin C, MMP-7, Kallikrein 11, kallikrein 8, DAN, </a:t>
            </a:r>
            <a:r>
              <a:rPr lang="en-US" altLang="ko-KR" sz="1000" dirty="0" err="1"/>
              <a:t>PTHrP</a:t>
            </a:r>
            <a:r>
              <a:rPr lang="en-US" altLang="ko-KR" sz="1000" dirty="0"/>
              <a:t>, PTN, </a:t>
            </a:r>
            <a:r>
              <a:rPr lang="en-US" altLang="ko-KR" sz="1000" dirty="0" err="1"/>
              <a:t>Granulysin</a:t>
            </a:r>
            <a:r>
              <a:rPr lang="en-US" altLang="ko-KR" sz="1000" dirty="0"/>
              <a:t>, SARP-2, LRP8, BSP, Neurotrophin-3, TFF3, STRATIFIN, GIB, MMP-13, TIMD3, SOD3, PPA6, HSP70 protein 8, Furin, HD-5, C1QRF, TMEDA, HSP 70, NET1, TM149, APLP2, RM14, PCD10:ECD, EphB6, MFAP2, WFDC1, Granzyme K, Cadherin-11:ECD, TGIF2</a:t>
            </a:r>
            <a:endParaRPr lang="ko-KR" altLang="en-US" sz="1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0DD72AF-26A8-80B2-5600-0FC88FAAE705}"/>
              </a:ext>
            </a:extLst>
          </p:cNvPr>
          <p:cNvSpPr txBox="1"/>
          <p:nvPr/>
        </p:nvSpPr>
        <p:spPr>
          <a:xfrm>
            <a:off x="127088" y="2492560"/>
            <a:ext cx="282779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FSTL3, IL-1 R4, CEA21, NPDC1, PXDC2:ECD, SIG15, SVEP1:Sushi 15-18, SVEP1:EGF-like domains 4-6, </a:t>
            </a:r>
            <a:r>
              <a:rPr lang="en-US" altLang="ko-KR" sz="1000" dirty="0" err="1"/>
              <a:t>hnRNP</a:t>
            </a:r>
            <a:r>
              <a:rPr lang="en-US" altLang="ko-KR" sz="1000" dirty="0"/>
              <a:t> C1/C2, THTR, MZF1, TPSB2, Collagen II, IGF-II receptor, MIP-5, CSTN2, NRN1L, TEN1L, AN32C, TRM6, NPS-PLA2, Fibrinogen, IGF-II receptor, Epithelial cell kinase, FGL1, RNAS6, TWEAK, </a:t>
            </a:r>
            <a:r>
              <a:rPr lang="en-US" altLang="ko-KR" sz="1000" dirty="0" err="1"/>
              <a:t>Secretoglobin</a:t>
            </a:r>
            <a:r>
              <a:rPr lang="en-US" altLang="ko-KR" sz="1000" dirty="0"/>
              <a:t> family 3A member 1, CRIM1:ECD, CRIP2</a:t>
            </a:r>
            <a:endParaRPr lang="ko-KR" altLang="en-US" sz="1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EAF8370-3A1C-FE97-A5D5-0E123AAEC78C}"/>
              </a:ext>
            </a:extLst>
          </p:cNvPr>
          <p:cNvSpPr txBox="1"/>
          <p:nvPr/>
        </p:nvSpPr>
        <p:spPr>
          <a:xfrm>
            <a:off x="4193859" y="2526334"/>
            <a:ext cx="2547262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>
                <a:ea typeface="맑은 고딕" panose="020B0503020000020004" pitchFamily="50" charset="-127"/>
              </a:rPr>
              <a:t>CNTFR alpha, TIMP-4, SCAR5, SOM2, SMOC1, CAN2, RSPO1, CD46, SUOX, CPLX1, NNMT, CLM9, KCTD6, Adiponectin, Troponin T, GAS1, SMOC1, CHL1</a:t>
            </a:r>
            <a:endParaRPr lang="ko-KR" altLang="en-US" sz="10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8E67DFC2-9A1D-8324-84B2-EFEA89EEC4DF}"/>
              </a:ext>
            </a:extLst>
          </p:cNvPr>
          <p:cNvSpPr txBox="1"/>
          <p:nvPr/>
        </p:nvSpPr>
        <p:spPr>
          <a:xfrm>
            <a:off x="2944527" y="2540724"/>
            <a:ext cx="1262452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WISP-2, TAGL, fibulin 5, VEGF-D, Rab-1C, SARP-2, SELM, HSPB6, MATN3, Calcyphosin, PDLI3, TNF </a:t>
            </a:r>
            <a:r>
              <a:rPr lang="en-US" altLang="ko-KR" sz="1000" dirty="0" err="1"/>
              <a:t>sR</a:t>
            </a:r>
            <a:r>
              <a:rPr lang="en-US" altLang="ko-KR" sz="1000" dirty="0"/>
              <a:t>-I, CRDL1, MIC-1, RNAS4</a:t>
            </a:r>
            <a:endParaRPr lang="ko-KR" altLang="en-US" sz="10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D41F65E-9752-C79C-888D-1783257AF2B0}"/>
              </a:ext>
            </a:extLst>
          </p:cNvPr>
          <p:cNvSpPr txBox="1"/>
          <p:nvPr/>
        </p:nvSpPr>
        <p:spPr>
          <a:xfrm>
            <a:off x="2967386" y="3803000"/>
            <a:ext cx="1248517" cy="1631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err="1"/>
              <a:t>Eotaxin</a:t>
            </a:r>
            <a:r>
              <a:rPr lang="en-US" altLang="ko-KR" sz="1000" dirty="0"/>
              <a:t>, ISK7, CTHR1, fibulin 5, TAGL, CALCB, Omentin, FZD8, B9D2, PPTC7, XRP2, RFC4, ES8L2, ANM2, HCC-1, Renin, NRX3B, </a:t>
            </a:r>
            <a:r>
              <a:rPr lang="en-US" altLang="ko-KR" sz="1000" dirty="0" err="1"/>
              <a:t>Fas</a:t>
            </a:r>
            <a:r>
              <a:rPr lang="en-US" altLang="ko-KR" sz="1000" dirty="0"/>
              <a:t> (soluble), PCDGA, UNC5B, QPCTL, SLAMF8</a:t>
            </a:r>
            <a:endParaRPr lang="ko-KR" altLang="en-US" sz="10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62E2196-392A-79D5-B70A-35F8D00C1FEC}"/>
              </a:ext>
            </a:extLst>
          </p:cNvPr>
          <p:cNvSpPr txBox="1"/>
          <p:nvPr/>
        </p:nvSpPr>
        <p:spPr>
          <a:xfrm>
            <a:off x="65384" y="8483713"/>
            <a:ext cx="1864802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Blue: OA</a:t>
            </a:r>
            <a:r>
              <a:rPr lang="el-GR" altLang="ko-KR" sz="1050" dirty="0"/>
              <a:t>β</a:t>
            </a:r>
            <a:r>
              <a:rPr lang="en-US" altLang="ko-KR" sz="1050" dirty="0"/>
              <a:t>T+/AD+</a:t>
            </a:r>
          </a:p>
          <a:p>
            <a:r>
              <a:rPr lang="en-US" altLang="ko-KR" sz="1050" dirty="0"/>
              <a:t>Red: OA</a:t>
            </a:r>
            <a:r>
              <a:rPr lang="el-GR" altLang="ko-KR" sz="1050" dirty="0"/>
              <a:t>β</a:t>
            </a:r>
            <a:r>
              <a:rPr lang="en-US" altLang="ko-KR" sz="1050" dirty="0"/>
              <a:t>T+/AD-</a:t>
            </a:r>
          </a:p>
          <a:p>
            <a:r>
              <a:rPr lang="en-US" altLang="ko-KR" sz="1050" dirty="0"/>
              <a:t>Yellow: OA</a:t>
            </a:r>
            <a:r>
              <a:rPr lang="el-GR" altLang="ko-KR" sz="1050" dirty="0"/>
              <a:t>β</a:t>
            </a:r>
            <a:r>
              <a:rPr lang="en-US" altLang="ko-KR" sz="1050" dirty="0"/>
              <a:t>T-/AD+</a:t>
            </a:r>
          </a:p>
        </p:txBody>
      </p:sp>
      <p:sp>
        <p:nvSpPr>
          <p:cNvPr id="3" name="Title 1">
            <a:extLst>
              <a:ext uri="{FF2B5EF4-FFF2-40B4-BE49-F238E27FC236}">
                <a16:creationId xmlns:a16="http://schemas.microsoft.com/office/drawing/2014/main" id="{BC33A203-E093-2249-8542-44DCD55BDEF9}"/>
              </a:ext>
            </a:extLst>
          </p:cNvPr>
          <p:cNvSpPr txBox="1">
            <a:spLocks/>
          </p:cNvSpPr>
          <p:nvPr/>
        </p:nvSpPr>
        <p:spPr>
          <a:xfrm>
            <a:off x="126300" y="71631"/>
            <a:ext cx="6665199" cy="546811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6858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Upregulated proteins in AD+ or OA</a:t>
            </a:r>
            <a:r>
              <a:rPr lang="el-GR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/AD- groups compared to OA</a:t>
            </a:r>
            <a:r>
              <a:rPr lang="el-GR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/AD- groups.</a:t>
            </a:r>
            <a:endParaRPr lang="ko-KR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28332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12A8E-9220-CCD4-CBFF-3625620A5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7276" y="-740"/>
            <a:ext cx="6603448" cy="716919"/>
          </a:xfrm>
        </p:spPr>
        <p:txBody>
          <a:bodyPr>
            <a:noAutofit/>
          </a:bodyPr>
          <a:lstStyle/>
          <a:p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4. Downregulated proteins in AD+ or OA</a:t>
            </a:r>
            <a:r>
              <a:rPr lang="el-GR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+/AD- groups compared to OA</a:t>
            </a:r>
            <a:r>
              <a:rPr lang="el-GR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8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-/AD- groups.</a:t>
            </a:r>
            <a:endParaRPr lang="ko-KR" altLang="en-US" sz="18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C8C14F8-8EF8-3E6A-6C56-5DD39FE0FAB2}"/>
              </a:ext>
            </a:extLst>
          </p:cNvPr>
          <p:cNvSpPr txBox="1"/>
          <p:nvPr/>
        </p:nvSpPr>
        <p:spPr>
          <a:xfrm>
            <a:off x="120609" y="7728964"/>
            <a:ext cx="1288580" cy="5599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13" dirty="0"/>
              <a:t>Blue: OA</a:t>
            </a:r>
            <a:r>
              <a:rPr lang="el-GR" altLang="ko-KR" sz="1013" dirty="0"/>
              <a:t>β</a:t>
            </a:r>
            <a:r>
              <a:rPr lang="en-US" altLang="ko-KR" sz="1013" dirty="0"/>
              <a:t>T+/AD+</a:t>
            </a:r>
          </a:p>
          <a:p>
            <a:r>
              <a:rPr lang="en-US" altLang="ko-KR" sz="1013" dirty="0"/>
              <a:t>Red: OA</a:t>
            </a:r>
            <a:r>
              <a:rPr lang="el-GR" altLang="ko-KR" sz="1013" dirty="0"/>
              <a:t>β</a:t>
            </a:r>
            <a:r>
              <a:rPr lang="en-US" altLang="ko-KR" sz="1013" dirty="0"/>
              <a:t>T+/AD-</a:t>
            </a:r>
          </a:p>
          <a:p>
            <a:r>
              <a:rPr lang="en-US" altLang="ko-KR" sz="1013" dirty="0"/>
              <a:t>Yellow: OA</a:t>
            </a:r>
            <a:r>
              <a:rPr lang="el-GR" altLang="ko-KR" sz="1013" dirty="0"/>
              <a:t>β</a:t>
            </a:r>
            <a:r>
              <a:rPr lang="en-US" altLang="ko-KR" sz="1013" dirty="0"/>
              <a:t>T-/AD+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EF25A172-CCDD-BDBB-31E1-560324CF2E3A}"/>
              </a:ext>
            </a:extLst>
          </p:cNvPr>
          <p:cNvSpPr/>
          <p:nvPr/>
        </p:nvSpPr>
        <p:spPr>
          <a:xfrm>
            <a:off x="211959" y="860733"/>
            <a:ext cx="6424666" cy="2329057"/>
          </a:xfrm>
          <a:prstGeom prst="rect">
            <a:avLst/>
          </a:prstGeom>
          <a:solidFill>
            <a:schemeClr val="accent1">
              <a:alpha val="57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>
              <a:solidFill>
                <a:schemeClr val="tx1"/>
              </a:solidFill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AB5A9514-4DD5-D802-9464-F372866E0096}"/>
              </a:ext>
            </a:extLst>
          </p:cNvPr>
          <p:cNvSpPr/>
          <p:nvPr/>
        </p:nvSpPr>
        <p:spPr>
          <a:xfrm>
            <a:off x="155439" y="2223428"/>
            <a:ext cx="2343778" cy="4003991"/>
          </a:xfrm>
          <a:prstGeom prst="rect">
            <a:avLst/>
          </a:prstGeom>
          <a:solidFill>
            <a:srgbClr val="FF0000">
              <a:alpha val="60000"/>
            </a:srgbClr>
          </a:solidFill>
        </p:spPr>
        <p:style>
          <a:lnRef idx="2">
            <a:schemeClr val="accent6">
              <a:shade val="50000"/>
            </a:schemeClr>
          </a:lnRef>
          <a:fillRef idx="1">
            <a:schemeClr val="accent6"/>
          </a:fillRef>
          <a:effectRef idx="0">
            <a:schemeClr val="accent6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dirty="0">
              <a:solidFill>
                <a:schemeClr val="tx1"/>
              </a:solidFill>
            </a:endParaRP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B59C6C6D-4811-42DC-7C0A-802512318160}"/>
              </a:ext>
            </a:extLst>
          </p:cNvPr>
          <p:cNvSpPr/>
          <p:nvPr/>
        </p:nvSpPr>
        <p:spPr>
          <a:xfrm>
            <a:off x="1764430" y="2226725"/>
            <a:ext cx="4928716" cy="5227917"/>
          </a:xfrm>
          <a:prstGeom prst="rect">
            <a:avLst/>
          </a:prstGeom>
          <a:solidFill>
            <a:srgbClr val="FFC000">
              <a:alpha val="60000"/>
            </a:srgbClr>
          </a:solidFill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000" dirty="0">
              <a:solidFill>
                <a:schemeClr val="tx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491BBE9-7444-04E8-E591-AA5B03836A07}"/>
              </a:ext>
            </a:extLst>
          </p:cNvPr>
          <p:cNvSpPr txBox="1"/>
          <p:nvPr/>
        </p:nvSpPr>
        <p:spPr>
          <a:xfrm>
            <a:off x="211958" y="860733"/>
            <a:ext cx="6415244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Integrin a1b1, ERP29, carboxylesterase (liver), DCNL5, UB2G2, SMAD1, PDLI1, CAZA1, Protein disulfide-isomerase, DAPP1, ARHI, URP2, ARC1B, DOT1L, RHG30, STX10, TMOD3, RAB18, CLM6, LT4R1, U2AF2, CIG49, HGS, PDGF-CC, CLCKB, SPOP, UGPA1, VPS29, S100A5, FLIP, RAB4A, SH3BGRL3-like protein, UGDH, HAOX1, SSDH, SYSC, CHM1A, LEGL, GRHPR, RTP4, RALB, CBX1, Platelet proteoglycan, GMPR1, RAB13, HLA-G, TSR2, BRK1, CAMLG, PHOP2, cIAP-1, TXNL1, SMAD5, BIN2, UBP12, ARNT, DAB2, LPL, PP4C, GGE2D, Gro-g, Rab-33A, EFCB1, RAB43, TXND9, RAB4B, LCE3C, BACD3, DTBP1, 5NT1A, NUD15, ACO12, Rab-7, Apo E, Glycogen phosphorylase, MO4L2, CABP2, NSUN6, MACD2, LRRF2, Gro-a, PD-L2, IgM, Thrombopoietin Receptor, PCSK7, Peroxiredoxin-5, Caspase-10:region 1, CYTN, PSMA, MINP1, GT251, </a:t>
            </a:r>
            <a:r>
              <a:rPr lang="en-US" altLang="ko-KR" sz="1000" dirty="0" err="1"/>
              <a:t>Stomatin</a:t>
            </a:r>
            <a:r>
              <a:rPr lang="en-US" altLang="ko-KR" sz="1000" dirty="0"/>
              <a:t>-like protein 2, VAPA, SULF2, </a:t>
            </a:r>
            <a:r>
              <a:rPr lang="en-US" altLang="ko-KR" sz="1000" dirty="0" err="1"/>
              <a:t>Cytidylate</a:t>
            </a:r>
            <a:r>
              <a:rPr lang="en-US" altLang="ko-KR" sz="1000" dirty="0"/>
              <a:t> kinase, ADAM 10:ECD, PEAR1:CD, STIM1:CD, EP3A, VAV3, NAD(P)H dehydrogenase</a:t>
            </a:r>
            <a:endParaRPr lang="ko-KR" altLang="en-US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4FB0776-F4CA-8CF3-0001-1E4C70B301A2}"/>
              </a:ext>
            </a:extLst>
          </p:cNvPr>
          <p:cNvSpPr txBox="1"/>
          <p:nvPr/>
        </p:nvSpPr>
        <p:spPr>
          <a:xfrm>
            <a:off x="158381" y="3211209"/>
            <a:ext cx="1563069" cy="30162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NUDC3, CTAP-III, PDE1A, TRML2, NEC2, NMS, PIN1, TEX29, Alpha enolase, PRPS1, DDX58, PSA7, PANK3, NAL10, ASH2L, RFESD, GRB14, S100A4, LIRA2, BTG, GGPPS, CRIP1, UB2D3, IGFBP-5, Cystatin B, SGK1, CTACK, TACC3, AT5F1, TGF-b1, AAMDC, FCSD1, ELP1, FNBP1, NFIA, Inhibin a subunit, HO-2, NAP-2, sTie-1, TSLP, BMX, TrkA, GCP-2, CD40 ligand (soluble), MFRP, FGR, PSA1, Lamin-B1, MBD4, MED-1, FST, Activin AB, </a:t>
            </a:r>
            <a:r>
              <a:rPr lang="en-US" altLang="ko-KR" sz="1000" dirty="0" err="1"/>
              <a:t>Endoplasmin</a:t>
            </a:r>
            <a:r>
              <a:rPr lang="en-US" altLang="ko-KR" sz="1000" dirty="0"/>
              <a:t>, IGFALS, ZP4, COX5B, NUDC:N-term</a:t>
            </a:r>
            <a:endParaRPr lang="ko-KR" altLang="en-US" sz="1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8FC0994-4750-4DB5-7898-4865EC3ED4E8}"/>
              </a:ext>
            </a:extLst>
          </p:cNvPr>
          <p:cNvSpPr txBox="1"/>
          <p:nvPr/>
        </p:nvSpPr>
        <p:spPr>
          <a:xfrm>
            <a:off x="2508964" y="3211663"/>
            <a:ext cx="4133017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Haptoglobin (Mixed Type), IL-13, BNP-32, MSP, PPIB, ASM3A, SEPR, NR1D1, CRAC1, PMEPA, CC167, calgranulin B, SIGL8, CC055, PCDGM, DRGX, KI3L3:CD, </a:t>
            </a:r>
            <a:r>
              <a:rPr lang="en-US" altLang="ko-KR" sz="1000" dirty="0" err="1"/>
              <a:t>Tpo</a:t>
            </a:r>
            <a:r>
              <a:rPr lang="en-US" altLang="ko-KR" sz="1000" dirty="0"/>
              <a:t>, SLAF5, TM234, NMU, ERLN1, CCPG1, L37A2, TMCC3:region 1, BDP1, C1RL1, VDR, B4GT5, RNF43, </a:t>
            </a:r>
            <a:r>
              <a:rPr lang="en-US" altLang="ko-KR" sz="1000" dirty="0" err="1"/>
              <a:t>megalin</a:t>
            </a:r>
            <a:r>
              <a:rPr lang="en-US" altLang="ko-KR" sz="1000" dirty="0"/>
              <a:t>, CABP8, PKHA4, TM119, TRML1:ITIM, F162B, RIC3, PPN, DCE1, KC1D, SCAR3:region 2, CR3L4, PPM1D, Apo A-V, INP5E, GP101, PLS3, GALE, MGAP, LFA-1 alpha-L chain, MYB, P4HA1, GP101, BRPF1, CXD2, KCTD5, WRIP1, VRK1, EFS, IMPA2, ZN175, LFA-1 beta-2, ZN134, PIWL1, ZN566, KCNF1, CASL, UBTD2, STAU2, S6A14, HIF-1a, ENOX2, RPR1A, KCNN1, SC5A8, FGF-16, IFN-lambda 1, RMI1, NAB1, SPSB1, OSM, STAB1, S100A3, SDF2, FGFP1, </a:t>
            </a:r>
            <a:r>
              <a:rPr lang="en-US" altLang="ko-KR" sz="1000" dirty="0" err="1"/>
              <a:t>Attractin</a:t>
            </a:r>
            <a:r>
              <a:rPr lang="en-US" altLang="ko-KR" sz="1000" dirty="0"/>
              <a:t>, ENPP6, </a:t>
            </a:r>
            <a:r>
              <a:rPr lang="en-US" altLang="ko-KR" sz="1000" dirty="0" err="1"/>
              <a:t>Biotinidase</a:t>
            </a:r>
            <a:r>
              <a:rPr lang="en-US" altLang="ko-KR" sz="1000" dirty="0"/>
              <a:t>, B3GN4, SDC3, NHRF3, DCNL1, DLRB2, CDA, Catechol O-methyltransferase, PP13, HOP, PEF1, CASQ2, Chk2, HMGA2, UBP28, SNP23, CNCG, CD6, EGLN3, UBP1/WDR48 Complex, NELFE, PAL4D, IFNL4, Integrin a5b1, Integrin a6, TAD2A, THAP2, RT14, Endothelial lipase, KCAB3, CS084, LACC1, VS10L, GAGC1, PWP2B, Dr1-associated corepressor, LRA25, RTN1, HES6, MA6D1, REM1, DMRTB, GTPBA, SAP, EZH2, Selenium-binding protein 1, NOMO2, Calgranulin A, LCE3B, LNP, P-Cadherin, LAG-1, PKC-D, Growth hormone receptor, a2-Antiplasmin, Heparin cofactor II, IFN-</a:t>
            </a:r>
            <a:r>
              <a:rPr lang="en-US" altLang="ko-KR" sz="1000" dirty="0" err="1"/>
              <a:t>aA</a:t>
            </a:r>
            <a:r>
              <a:rPr lang="en-US" altLang="ko-KR" sz="1000" dirty="0"/>
              <a:t>, Cadherin-6, MASP3:Light, ANGL4, IL-12 RB2, BMP RII, IF4A3, Tropomyosin 1 alpha chain, MO2R1:ECD, DRAK2, Ficolin-3, RNS10, FAM3B, CI061, KTDAP, PI15, F19A1, GNAS3, LECT2, REL3, MAMC2, RSPO1, IFN16, </a:t>
            </a:r>
            <a:r>
              <a:rPr lang="en-US" altLang="ko-KR" sz="1000" dirty="0" err="1"/>
              <a:t>Sema</a:t>
            </a:r>
            <a:r>
              <a:rPr lang="en-US" altLang="ko-KR" sz="1000" dirty="0"/>
              <a:t> E, PSG6, LY66D, F19A4, LAML2, VTM2L, CCD19, CQ078:N-term, ATL1, APEL, HAAH, FSTL5, IGDC3:ECD, ANK2, Lectin (mannose-binding 2), KLRF1, GOS-28, IBPL1, SERF1, CCD56, SCN4B, B3GN2, PCDB7, ITM2B, CA186, LIRA4, SIGIRR, Gastrin-releasing peptide, MMP-7, </a:t>
            </a:r>
            <a:r>
              <a:rPr lang="en-US" altLang="ko-KR" sz="1000" dirty="0" err="1"/>
              <a:t>Dermokine</a:t>
            </a:r>
            <a:r>
              <a:rPr lang="en-US" altLang="ko-KR" sz="1000" dirty="0"/>
              <a:t>, ZPBP1, ADAM 10:CD, OLFL3, TPPC5, HIKES, CENPW, Glycodelin, NPM1, CSPG4, ROS1, CA063, UROL1, FLRT3:CD, S31D4, SYT2, CTNA2, PCDB1, PRS35, ATP4B</a:t>
            </a:r>
            <a:endParaRPr lang="ko-KR" altLang="en-US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AF4AD8A-495E-7861-A551-74551D878188}"/>
              </a:ext>
            </a:extLst>
          </p:cNvPr>
          <p:cNvSpPr txBox="1"/>
          <p:nvPr/>
        </p:nvSpPr>
        <p:spPr>
          <a:xfrm>
            <a:off x="1764431" y="2178663"/>
            <a:ext cx="756780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altLang="ko-KR" sz="1000" dirty="0"/>
              <a:t>Apo A-I, Cytochrome P450 3A4, R4RL1, KCMB3</a:t>
            </a:r>
            <a:endParaRPr lang="ko-KR" altLang="en-US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8B0427-4AF1-0EE5-90CC-BE9F7C73D50C}"/>
              </a:ext>
            </a:extLst>
          </p:cNvPr>
          <p:cNvSpPr txBox="1"/>
          <p:nvPr/>
        </p:nvSpPr>
        <p:spPr>
          <a:xfrm>
            <a:off x="219349" y="2202650"/>
            <a:ext cx="145585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LIN7B, PCDG2, TCP-1-epsilon, KAT3, TCP-1-theta, SC5A5, EDC4, TCPH, SDSL, TCPA, CBR4, ABCF3, LRP, HPG-, B7-H2, FXRD1</a:t>
            </a:r>
            <a:endParaRPr lang="ko-KR" altLang="en-US" sz="1000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8C655AB-6317-0808-2DF4-4C8347BE7AE2}"/>
              </a:ext>
            </a:extLst>
          </p:cNvPr>
          <p:cNvSpPr txBox="1"/>
          <p:nvPr/>
        </p:nvSpPr>
        <p:spPr>
          <a:xfrm>
            <a:off x="2507773" y="2234074"/>
            <a:ext cx="390470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KCIP4, Apo L1, OA synthetase, RET</a:t>
            </a:r>
            <a:endParaRPr lang="ko-KR" altLang="en-US" sz="1000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D3A5695-9EAE-7096-CD9D-914C38F0650F}"/>
              </a:ext>
            </a:extLst>
          </p:cNvPr>
          <p:cNvSpPr txBox="1"/>
          <p:nvPr/>
        </p:nvSpPr>
        <p:spPr>
          <a:xfrm>
            <a:off x="1772615" y="3212345"/>
            <a:ext cx="64244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SIA10, NREP</a:t>
            </a:r>
            <a:endParaRPr lang="ko-KR" altLang="en-US" sz="1000" dirty="0"/>
          </a:p>
        </p:txBody>
      </p:sp>
    </p:spTree>
    <p:extLst>
      <p:ext uri="{BB962C8B-B14F-4D97-AF65-F5344CB8AC3E}">
        <p14:creationId xmlns:p14="http://schemas.microsoft.com/office/powerpoint/2010/main" val="133221843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2512A8E-9220-CCD4-CBFF-3625620A5E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0" y="0"/>
            <a:ext cx="6857999" cy="821872"/>
          </a:xfrm>
        </p:spPr>
        <p:txBody>
          <a:bodyPr>
            <a:normAutofit/>
          </a:bodyPr>
          <a:lstStyle/>
          <a:p>
            <a:r>
              <a:rPr lang="en-US" altLang="ko-KR" sz="2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upplementary Figure 5. Validation of </a:t>
            </a:r>
            <a:r>
              <a:rPr lang="en-US" altLang="ko-KR" sz="2000" b="1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20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data using ELISA assays. </a:t>
            </a:r>
            <a:endParaRPr lang="ko-KR" alt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736E957-52DE-5D26-80C4-3184DC4F8AAA}"/>
              </a:ext>
            </a:extLst>
          </p:cNvPr>
          <p:cNvSpPr txBox="1"/>
          <p:nvPr/>
        </p:nvSpPr>
        <p:spPr>
          <a:xfrm>
            <a:off x="131678" y="5678692"/>
            <a:ext cx="6581638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 levels of adiponectin, TIMP-4, and IGFBP-2 exhibited significant increases in individuals with Alzheimer's disease when assessed using both </a:t>
            </a:r>
            <a:r>
              <a:rPr lang="en-US" altLang="ko-KR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)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nd ELISA 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A')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Expression levels of fibrinogen, alpha-enolase, and IGFBP-7 were significantly altered in subjects with high OA</a:t>
            </a:r>
            <a:r>
              <a:rPr lang="el-GR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β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 values as determined by the </a:t>
            </a:r>
            <a:r>
              <a:rPr lang="en-US" altLang="ko-KR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ssay 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)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. ELISA measurements </a:t>
            </a:r>
            <a:r>
              <a:rPr lang="en-US" altLang="ko-KR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(B')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did not show statistically significant changes, though the direction of these changes closely mirrored the results obtained from the </a:t>
            </a:r>
            <a:r>
              <a:rPr lang="en-US" altLang="ko-KR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SOMAscan</a:t>
            </a:r>
            <a:r>
              <a:rPr lang="en-US" altLang="ko-KR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assay. </a:t>
            </a:r>
            <a:r>
              <a:rPr lang="en-US" altLang="ko-KR" sz="1200" kern="100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*p&lt;0.05, **p&lt;0.01.</a:t>
            </a:r>
            <a:endParaRPr lang="ko-KR" altLang="en-US" sz="1200" dirty="0"/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92AC4137-2F27-9660-FFE9-22C417C3FB09}"/>
              </a:ext>
            </a:extLst>
          </p:cNvPr>
          <p:cNvGrpSpPr/>
          <p:nvPr/>
        </p:nvGrpSpPr>
        <p:grpSpPr>
          <a:xfrm>
            <a:off x="0" y="1108525"/>
            <a:ext cx="6858000" cy="2128182"/>
            <a:chOff x="0" y="1108525"/>
            <a:chExt cx="6858000" cy="2128182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684EC3B-62BB-D38A-3E7E-31061CD3BE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1152413"/>
              <a:ext cx="6858000" cy="2084294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F0794745-DABF-83A7-2416-23DEE8762451}"/>
                </a:ext>
              </a:extLst>
            </p:cNvPr>
            <p:cNvSpPr txBox="1"/>
            <p:nvPr/>
          </p:nvSpPr>
          <p:spPr>
            <a:xfrm>
              <a:off x="146508" y="1108525"/>
              <a:ext cx="4156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49C6B578-D700-A57F-22F1-BBD82BF85F0E}"/>
                </a:ext>
              </a:extLst>
            </p:cNvPr>
            <p:cNvSpPr txBox="1"/>
            <p:nvPr/>
          </p:nvSpPr>
          <p:spPr>
            <a:xfrm>
              <a:off x="3604083" y="1108525"/>
              <a:ext cx="4156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’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FAC76938-FC1F-F7AC-A13B-842C647DFB3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08983" y="2992028"/>
              <a:ext cx="2603999" cy="216000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C0F5965-1451-31BD-FC8D-4E17E4BAE05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054452" y="2992332"/>
              <a:ext cx="2603999" cy="216000"/>
            </a:xfrm>
            <a:prstGeom prst="rect">
              <a:avLst/>
            </a:prstGeom>
          </p:spPr>
        </p:pic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68CDC10-4AD2-8DEB-123B-3E268462A029}"/>
              </a:ext>
            </a:extLst>
          </p:cNvPr>
          <p:cNvGrpSpPr/>
          <p:nvPr/>
        </p:nvGrpSpPr>
        <p:grpSpPr>
          <a:xfrm>
            <a:off x="0" y="3397718"/>
            <a:ext cx="6858000" cy="2119963"/>
            <a:chOff x="0" y="3397718"/>
            <a:chExt cx="6858000" cy="2119963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C172EF2B-B14F-B506-4CBB-E1AA22582243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3397718"/>
              <a:ext cx="6858000" cy="2119963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6F7F66D7-B11A-7DC5-766A-7A48746C034C}"/>
                </a:ext>
              </a:extLst>
            </p:cNvPr>
            <p:cNvSpPr txBox="1"/>
            <p:nvPr/>
          </p:nvSpPr>
          <p:spPr>
            <a:xfrm>
              <a:off x="146508" y="3415480"/>
              <a:ext cx="4156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4B4399DB-444B-DADC-C2F4-9304B458E5A0}"/>
                </a:ext>
              </a:extLst>
            </p:cNvPr>
            <p:cNvSpPr txBox="1"/>
            <p:nvPr/>
          </p:nvSpPr>
          <p:spPr>
            <a:xfrm>
              <a:off x="3604083" y="3415480"/>
              <a:ext cx="41564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’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4" name="Picture 13">
              <a:extLst>
                <a:ext uri="{FF2B5EF4-FFF2-40B4-BE49-F238E27FC236}">
                  <a16:creationId xmlns:a16="http://schemas.microsoft.com/office/drawing/2014/main" id="{F51460C0-8FDC-F8FD-72F2-EC2610874C32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81660" y="5267998"/>
              <a:ext cx="2772000" cy="236181"/>
            </a:xfrm>
            <a:prstGeom prst="rect">
              <a:avLst/>
            </a:prstGeom>
          </p:spPr>
        </p:pic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FBE23D43-6485-0549-E004-F294BBC780C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954870" y="5268798"/>
              <a:ext cx="2772000" cy="236181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810057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825</TotalTime>
  <Words>3014</Words>
  <Application>Microsoft Office PowerPoint</Application>
  <PresentationFormat>화면 슬라이드 쇼(4:3)</PresentationFormat>
  <Paragraphs>169</Paragraphs>
  <Slides>6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12" baseType="lpstr">
      <vt:lpstr>맑은 고딕</vt:lpstr>
      <vt:lpstr>Arial</vt:lpstr>
      <vt:lpstr>Calibri</vt:lpstr>
      <vt:lpstr>Calibri Light</vt:lpstr>
      <vt:lpstr>Times New Roman</vt:lpstr>
      <vt:lpstr>Office Theme</vt:lpstr>
      <vt:lpstr>PowerPoint 프레젠테이션</vt:lpstr>
      <vt:lpstr>PowerPoint 프레젠테이션</vt:lpstr>
      <vt:lpstr>PowerPoint 프레젠테이션</vt:lpstr>
      <vt:lpstr>PowerPoint 프레젠테이션</vt:lpstr>
      <vt:lpstr>Supplementary Figure 4. Downregulated proteins in AD+ or OAβT+/AD- groups compared to OAβT-/AD- groups.</vt:lpstr>
      <vt:lpstr>Supplementary Figure 5. Validation of SOMAscan data using ELISA assays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2024/04/09 SR팀 Bi-weekly meeting</dc:title>
  <dc:creator>Hyunjung Oh</dc:creator>
  <cp:lastModifiedBy>Hyunjung Oh</cp:lastModifiedBy>
  <cp:revision>68</cp:revision>
  <cp:lastPrinted>2025-03-28T09:42:50Z</cp:lastPrinted>
  <dcterms:created xsi:type="dcterms:W3CDTF">2024-04-08T01:22:14Z</dcterms:created>
  <dcterms:modified xsi:type="dcterms:W3CDTF">2026-02-13T06:38:47Z</dcterms:modified>
</cp:coreProperties>
</file>